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74" r:id="rId2"/>
    <p:sldId id="275" r:id="rId3"/>
    <p:sldId id="276" r:id="rId4"/>
    <p:sldId id="285" r:id="rId5"/>
    <p:sldId id="282" r:id="rId6"/>
    <p:sldId id="279" r:id="rId7"/>
    <p:sldId id="283" r:id="rId8"/>
    <p:sldId id="284" r:id="rId9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85" autoAdjust="0"/>
    <p:restoredTop sz="89016" autoAdjust="0"/>
  </p:normalViewPr>
  <p:slideViewPr>
    <p:cSldViewPr snapToGrid="0">
      <p:cViewPr varScale="1">
        <p:scale>
          <a:sx n="99" d="100"/>
          <a:sy n="99" d="100"/>
        </p:scale>
        <p:origin x="906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6CC651-E8EA-4781-8DA1-825D0C4A464B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386196-48B0-48D2-A2DB-5C25666AD39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4461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F17971-E3D4-4FAA-9DC6-4BE48711C93B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24453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386196-48B0-48D2-A2DB-5C25666AD393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8476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386196-48B0-48D2-A2DB-5C25666AD393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9271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FCB4C1-B317-9422-E5D0-7F94980826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7D02DE3-DF4C-8A09-A5F3-82E0487F89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E875F8F-87E0-8C02-777F-75BF5AE54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7EA2AE-DA5E-3D22-B06F-B043B276A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90A298-C7BE-7A02-073E-1F2F3F170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0838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48C4C9-AD47-CB98-3D25-F40B36475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AB3969D-545C-5E4C-5EBB-0F61C89003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27D1BB2-8EC0-9CEF-E3A2-855C7A5A5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C9E8C7E-3BEF-BD81-8DAF-A8BD95E9E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F5D3183-82CC-4D98-8C78-6C34ED7F1C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3563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19D9826-8B4E-E5C5-895F-DDC4EDB4C8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53BBC95-6A9B-CF8E-1BEE-C83B050757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C557B82-9B78-668F-8689-C5054F9E3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0E2A588-F63E-2032-DC93-A95EBA933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AACD43A-E8CF-18CE-36FB-F89E41CE2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8660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116B7FF-EAE7-A2A1-D763-01C06091ED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DE8981A-1B07-B925-3837-6B1AAEEFEB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A06A02E-0663-2581-A386-29392F203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35962F1-9F4E-FBA4-78E9-54179387C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4E9878-FD12-E949-004D-22C83BA3E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2037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B5028FA-903F-D7DD-25E3-E8C3D507C2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86B0CB9-1FAD-7F39-F9DA-009C660DA0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A3FF7B-F7DD-5DDB-D79B-AF78A8354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4FAC72C-7E39-1566-BE77-EBEA639D3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26B86BA-943C-C176-FFFC-149938400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4148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7E0F66-7236-9577-C0CD-72BD2AB52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0F8799F-76C7-061A-C57A-77EAF47BC4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7477742-ED24-6477-7943-5C837D34E1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6044DD1-1C0F-39B4-3B54-F5ACF8578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41EFAD5-DA54-59CA-5794-FE0184551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1BF1979-60C3-A90E-9E4B-DFBA8F9D6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8434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2F14368-14CB-1097-3D07-97341FB1B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98C556E-ED44-D9B6-0AA6-16161E73B1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6896312-8814-1F36-10A6-3D89594E46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A67863B-98F2-8063-E170-B910B27DE9E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E73EEAD-AC15-EB1D-A854-7AC5DA244C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968F220-545F-20B2-A803-8E4FDE09D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070C7CC-A852-78AA-02D3-61A8A2126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8716382-FC76-B88C-DD99-BF950394B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9220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ECA3F-98F5-70C8-F21F-0E194F361F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FD0CFDB-F328-A7CA-5E7A-A5283D0D6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89DE5A5-CF8E-B8D2-3301-52B424EE8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9B5CFBE-FD61-8A39-2886-184BF6D9E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2955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CEB1997-6E75-F341-A6A6-6758CA96F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445CAF0-E9FA-2379-E510-689102158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BE15FB3-19F1-1C95-CD53-B8972312E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3285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00F256-DA2A-BBC2-4F99-560924DE3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7F0BB69-1DB4-0ED6-28F5-420A98004E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85DC895-39AA-B3AC-7322-A915B173D0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DDA59C0-E211-5B1C-CC01-7023ADF1CE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54AAF8-E31E-F38F-A547-E11658CF4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E8AEB66-9307-0C75-1162-FA1D812C1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1587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D3BA60C-94F0-E6F4-A448-20FADFBCA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6B66EA0-F871-2CDA-3939-6DCAE637C8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9B4710-F1D9-7453-9D0E-30689176F4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0322EC5-8170-9F78-E87B-DC5ABAF9E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5FEA031-E78E-EBB3-4829-89F09C9AC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66F3C70-81C1-26B0-2222-3924146FB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4755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9ED4E16-1841-EE24-9FB5-10E2562A4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5587337-062B-3F98-F1DA-5B7221BDD6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619C640-B86D-C840-B9FD-A151F2E3FC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E7024-27C5-4780-9B76-71304B75F3B8}" type="datetimeFigureOut">
              <a:rPr lang="ko-KR" altLang="en-US" smtClean="0"/>
              <a:t>2023-11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53138CB-037E-D89F-2034-D5C8B027C2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755502F-A321-620F-E786-627C8821AA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AB9E8-347E-4D3F-BA6E-7A95A1A4183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0944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16" name="직선 화살표 연결선 215"/>
          <p:cNvCxnSpPr>
            <a:stCxn id="62" idx="1"/>
            <a:endCxn id="248" idx="1"/>
          </p:cNvCxnSpPr>
          <p:nvPr/>
        </p:nvCxnSpPr>
        <p:spPr>
          <a:xfrm>
            <a:off x="3266937" y="2767567"/>
            <a:ext cx="2828302" cy="1346965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 flipV="1">
            <a:off x="3201010" y="2767566"/>
            <a:ext cx="57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오른쪽 화살표 60"/>
          <p:cNvSpPr/>
          <p:nvPr/>
        </p:nvSpPr>
        <p:spPr>
          <a:xfrm>
            <a:off x="3329184" y="2620143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2" name="TextBox 61"/>
          <p:cNvSpPr txBox="1"/>
          <p:nvPr/>
        </p:nvSpPr>
        <p:spPr>
          <a:xfrm>
            <a:off x="3266937" y="2629067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OsU3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오른쪽 화살표 62"/>
          <p:cNvSpPr/>
          <p:nvPr/>
        </p:nvSpPr>
        <p:spPr>
          <a:xfrm>
            <a:off x="3980276" y="2620143"/>
            <a:ext cx="12656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TextBox 63"/>
          <p:cNvSpPr txBox="1"/>
          <p:nvPr/>
        </p:nvSpPr>
        <p:spPr>
          <a:xfrm>
            <a:off x="3536788" y="2950352"/>
            <a:ext cx="1159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gRNA scaffold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오른쪽 화살표 64"/>
          <p:cNvSpPr/>
          <p:nvPr/>
        </p:nvSpPr>
        <p:spPr>
          <a:xfrm>
            <a:off x="4653503" y="2620143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TextBox 65"/>
          <p:cNvSpPr txBox="1"/>
          <p:nvPr/>
        </p:nvSpPr>
        <p:spPr>
          <a:xfrm>
            <a:off x="4651368" y="2629067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35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오른쪽 화살표 66"/>
          <p:cNvSpPr/>
          <p:nvPr/>
        </p:nvSpPr>
        <p:spPr>
          <a:xfrm>
            <a:off x="5286148" y="2620143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오른쪽 화살표 67"/>
          <p:cNvSpPr/>
          <p:nvPr/>
        </p:nvSpPr>
        <p:spPr>
          <a:xfrm>
            <a:off x="5377651" y="2620143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오른쪽 화살표 68"/>
          <p:cNvSpPr/>
          <p:nvPr/>
        </p:nvSpPr>
        <p:spPr>
          <a:xfrm>
            <a:off x="5482007" y="2620143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TextBox 69"/>
          <p:cNvSpPr txBox="1"/>
          <p:nvPr/>
        </p:nvSpPr>
        <p:spPr>
          <a:xfrm>
            <a:off x="4739385" y="2950352"/>
            <a:ext cx="543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ttB1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꺾인 연결선 70"/>
          <p:cNvCxnSpPr/>
          <p:nvPr/>
        </p:nvCxnSpPr>
        <p:spPr>
          <a:xfrm rot="5400000">
            <a:off x="5171071" y="2911463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5545829" y="2950352"/>
            <a:ext cx="901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V40 NLS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꺾인 연결선 72"/>
          <p:cNvCxnSpPr/>
          <p:nvPr/>
        </p:nvCxnSpPr>
        <p:spPr>
          <a:xfrm rot="16200000" flipH="1">
            <a:off x="5496469" y="2915581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오른쪽 화살표 73"/>
          <p:cNvSpPr/>
          <p:nvPr/>
        </p:nvSpPr>
        <p:spPr>
          <a:xfrm>
            <a:off x="5586363" y="2620143"/>
            <a:ext cx="224095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5" name="TextBox 74"/>
          <p:cNvSpPr txBox="1"/>
          <p:nvPr/>
        </p:nvSpPr>
        <p:spPr>
          <a:xfrm>
            <a:off x="6133838" y="2629067"/>
            <a:ext cx="7296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SpCas9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오른쪽 화살표 75"/>
          <p:cNvSpPr/>
          <p:nvPr/>
        </p:nvSpPr>
        <p:spPr>
          <a:xfrm>
            <a:off x="7841640" y="2620143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7" name="TextBox 76"/>
          <p:cNvSpPr txBox="1"/>
          <p:nvPr/>
        </p:nvSpPr>
        <p:spPr>
          <a:xfrm>
            <a:off x="6954421" y="2950352"/>
            <a:ext cx="867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PM NLS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꺾인 연결선 77"/>
          <p:cNvCxnSpPr/>
          <p:nvPr/>
        </p:nvCxnSpPr>
        <p:spPr>
          <a:xfrm rot="5400000">
            <a:off x="7730491" y="2923561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오른쪽 화살표 78"/>
          <p:cNvSpPr/>
          <p:nvPr/>
        </p:nvSpPr>
        <p:spPr>
          <a:xfrm flipH="1">
            <a:off x="7979160" y="2620143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0" name="TextBox 79"/>
          <p:cNvSpPr txBox="1"/>
          <p:nvPr/>
        </p:nvSpPr>
        <p:spPr>
          <a:xfrm>
            <a:off x="8080129" y="2950352"/>
            <a:ext cx="543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ttB2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꺾인 연결선 80"/>
          <p:cNvCxnSpPr/>
          <p:nvPr/>
        </p:nvCxnSpPr>
        <p:spPr>
          <a:xfrm rot="16200000" flipH="1">
            <a:off x="8015510" y="2937411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오른쪽 화살표 81"/>
          <p:cNvSpPr/>
          <p:nvPr/>
        </p:nvSpPr>
        <p:spPr>
          <a:xfrm>
            <a:off x="8072063" y="2620143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3" name="오른쪽 화살표 82"/>
          <p:cNvSpPr/>
          <p:nvPr/>
        </p:nvSpPr>
        <p:spPr>
          <a:xfrm>
            <a:off x="8190620" y="2620143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TextBox 83"/>
          <p:cNvSpPr txBox="1"/>
          <p:nvPr/>
        </p:nvSpPr>
        <p:spPr>
          <a:xfrm>
            <a:off x="8178867" y="2629067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NO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꺾인 연결선 84"/>
          <p:cNvCxnSpPr>
            <a:stCxn id="68" idx="0"/>
          </p:cNvCxnSpPr>
          <p:nvPr/>
        </p:nvCxnSpPr>
        <p:spPr>
          <a:xfrm rot="5400000" flipH="1" flipV="1">
            <a:off x="5393380" y="2448357"/>
            <a:ext cx="195608" cy="147964"/>
          </a:xfrm>
          <a:prstGeom prst="bentConnector2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5474708" y="2277574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xFLAG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꺾인 연결선 87"/>
          <p:cNvCxnSpPr/>
          <p:nvPr/>
        </p:nvCxnSpPr>
        <p:spPr>
          <a:xfrm rot="16200000" flipV="1">
            <a:off x="8004387" y="2532512"/>
            <a:ext cx="166924" cy="2175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7913722" y="2277574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오른쪽 화살표 128"/>
          <p:cNvSpPr/>
          <p:nvPr/>
        </p:nvSpPr>
        <p:spPr>
          <a:xfrm>
            <a:off x="3930616" y="2620143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35" name="직선 화살표 연결선 134"/>
          <p:cNvCxnSpPr/>
          <p:nvPr/>
        </p:nvCxnSpPr>
        <p:spPr>
          <a:xfrm>
            <a:off x="4051200" y="2781996"/>
            <a:ext cx="0" cy="24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직선 화살표 연결선 135"/>
          <p:cNvCxnSpPr/>
          <p:nvPr/>
        </p:nvCxnSpPr>
        <p:spPr>
          <a:xfrm flipV="1">
            <a:off x="3943430" y="2485493"/>
            <a:ext cx="0" cy="24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/>
          <p:cNvSpPr txBox="1"/>
          <p:nvPr/>
        </p:nvSpPr>
        <p:spPr>
          <a:xfrm>
            <a:off x="3371358" y="1896409"/>
            <a:ext cx="106311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luC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luB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gRNA-GluA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2920356" y="596587"/>
            <a:ext cx="61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오른쪽 화살표 13"/>
          <p:cNvSpPr/>
          <p:nvPr/>
        </p:nvSpPr>
        <p:spPr>
          <a:xfrm>
            <a:off x="3382628" y="451528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3320381" y="460452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OsU3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오른쪽 화살표 15"/>
          <p:cNvSpPr/>
          <p:nvPr/>
        </p:nvSpPr>
        <p:spPr>
          <a:xfrm>
            <a:off x="4045819" y="451528"/>
            <a:ext cx="12656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3658720" y="118351"/>
            <a:ext cx="1159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gRNA scaffold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오른쪽 화살표 17"/>
          <p:cNvSpPr/>
          <p:nvPr/>
        </p:nvSpPr>
        <p:spPr>
          <a:xfrm>
            <a:off x="4706947" y="451528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4704812" y="460452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35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오른쪽 화살표 19"/>
          <p:cNvSpPr/>
          <p:nvPr/>
        </p:nvSpPr>
        <p:spPr>
          <a:xfrm>
            <a:off x="5339592" y="451528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오른쪽 화살표 20"/>
          <p:cNvSpPr/>
          <p:nvPr/>
        </p:nvSpPr>
        <p:spPr>
          <a:xfrm>
            <a:off x="5431095" y="451528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" name="오른쪽 화살표 21"/>
          <p:cNvSpPr/>
          <p:nvPr/>
        </p:nvSpPr>
        <p:spPr>
          <a:xfrm>
            <a:off x="5535451" y="451528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4792829" y="756459"/>
            <a:ext cx="543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ttB1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꺾인 연결선 24"/>
          <p:cNvCxnSpPr/>
          <p:nvPr/>
        </p:nvCxnSpPr>
        <p:spPr>
          <a:xfrm rot="5400000">
            <a:off x="5224515" y="742848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599273" y="756459"/>
            <a:ext cx="901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V40 NLS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꺾인 연결선 28"/>
          <p:cNvCxnSpPr/>
          <p:nvPr/>
        </p:nvCxnSpPr>
        <p:spPr>
          <a:xfrm rot="16200000" flipH="1">
            <a:off x="5549913" y="746966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오른쪽 화살표 29"/>
          <p:cNvSpPr/>
          <p:nvPr/>
        </p:nvSpPr>
        <p:spPr>
          <a:xfrm>
            <a:off x="5639807" y="451528"/>
            <a:ext cx="224095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TextBox 30"/>
          <p:cNvSpPr txBox="1"/>
          <p:nvPr/>
        </p:nvSpPr>
        <p:spPr>
          <a:xfrm>
            <a:off x="6187282" y="460452"/>
            <a:ext cx="7296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SpCas9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오른쪽 화살표 31"/>
          <p:cNvSpPr/>
          <p:nvPr/>
        </p:nvSpPr>
        <p:spPr>
          <a:xfrm>
            <a:off x="7895084" y="451528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7007865" y="756459"/>
            <a:ext cx="867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PM NLS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꺾인 연결선 34"/>
          <p:cNvCxnSpPr/>
          <p:nvPr/>
        </p:nvCxnSpPr>
        <p:spPr>
          <a:xfrm rot="5400000">
            <a:off x="7783935" y="754946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오른쪽 화살표 35"/>
          <p:cNvSpPr/>
          <p:nvPr/>
        </p:nvSpPr>
        <p:spPr>
          <a:xfrm flipH="1">
            <a:off x="8032604" y="451528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/>
          <p:cNvSpPr txBox="1"/>
          <p:nvPr/>
        </p:nvSpPr>
        <p:spPr>
          <a:xfrm>
            <a:off x="8133573" y="756459"/>
            <a:ext cx="5437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ttB2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꺾인 연결선 37"/>
          <p:cNvCxnSpPr/>
          <p:nvPr/>
        </p:nvCxnSpPr>
        <p:spPr>
          <a:xfrm rot="16200000" flipH="1">
            <a:off x="8068954" y="768796"/>
            <a:ext cx="140558" cy="128644"/>
          </a:xfrm>
          <a:prstGeom prst="bentConnector3">
            <a:avLst>
              <a:gd name="adj1" fmla="val 102747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오른쪽 화살표 38"/>
          <p:cNvSpPr/>
          <p:nvPr/>
        </p:nvSpPr>
        <p:spPr>
          <a:xfrm>
            <a:off x="8125507" y="451528"/>
            <a:ext cx="7910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오른쪽 화살표 40"/>
          <p:cNvSpPr/>
          <p:nvPr/>
        </p:nvSpPr>
        <p:spPr>
          <a:xfrm>
            <a:off x="8244064" y="451528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TextBox 41"/>
          <p:cNvSpPr txBox="1"/>
          <p:nvPr/>
        </p:nvSpPr>
        <p:spPr>
          <a:xfrm>
            <a:off x="8232311" y="460452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NO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꺾인 연결선 42"/>
          <p:cNvCxnSpPr>
            <a:stCxn id="21" idx="0"/>
          </p:cNvCxnSpPr>
          <p:nvPr/>
        </p:nvCxnSpPr>
        <p:spPr>
          <a:xfrm rot="5400000" flipH="1" flipV="1">
            <a:off x="5446824" y="279742"/>
            <a:ext cx="195608" cy="147964"/>
          </a:xfrm>
          <a:prstGeom prst="bentConnector2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5528152" y="108959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xFLAG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꺾인 연결선 53"/>
          <p:cNvCxnSpPr/>
          <p:nvPr/>
        </p:nvCxnSpPr>
        <p:spPr>
          <a:xfrm rot="16200000" flipV="1">
            <a:off x="8057831" y="363897"/>
            <a:ext cx="166924" cy="2175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7967166" y="108959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직선 화살표 연결선 137"/>
          <p:cNvCxnSpPr/>
          <p:nvPr/>
        </p:nvCxnSpPr>
        <p:spPr>
          <a:xfrm flipV="1">
            <a:off x="4120152" y="322726"/>
            <a:ext cx="0" cy="24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5" name="그룹 294"/>
          <p:cNvGrpSpPr/>
          <p:nvPr/>
        </p:nvGrpSpPr>
        <p:grpSpPr>
          <a:xfrm>
            <a:off x="5785098" y="1273511"/>
            <a:ext cx="5519836" cy="646331"/>
            <a:chOff x="5029388" y="1311157"/>
            <a:chExt cx="5519836" cy="646331"/>
          </a:xfrm>
        </p:grpSpPr>
        <p:sp>
          <p:nvSpPr>
            <p:cNvPr id="59" name="아래쪽 화살표 58"/>
            <p:cNvSpPr/>
            <p:nvPr/>
          </p:nvSpPr>
          <p:spPr>
            <a:xfrm>
              <a:off x="5029388" y="1322537"/>
              <a:ext cx="449434" cy="618873"/>
            </a:xfrm>
            <a:prstGeom prst="downArrow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623730" y="1311157"/>
              <a:ext cx="492549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28600" indent="-228600">
                <a:buAutoNum type="arabicPeriod"/>
              </a:pP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Digesting pRGE31 vector with </a:t>
              </a:r>
              <a:r>
                <a:rPr lang="en-US" altLang="ko-K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sa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I, a type IIS restriction enzyme</a:t>
              </a:r>
            </a:p>
            <a:p>
              <a:pPr marL="228600" indent="-228600">
                <a:buAutoNum type="arabicPeriod"/>
              </a:pP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Insertion of designed </a:t>
              </a:r>
              <a:r>
                <a:rPr lang="en-US" altLang="ko-K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gRNAs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containing target sequences by </a:t>
              </a:r>
              <a:r>
                <a:rPr lang="en-US" altLang="ko-K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EBuilder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iFi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DNA Assembly Master Mix (#E2621)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오른쪽 화살표 103"/>
          <p:cNvSpPr/>
          <p:nvPr/>
        </p:nvSpPr>
        <p:spPr>
          <a:xfrm>
            <a:off x="3999538" y="447879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07" name="꺾인 연결선 106"/>
          <p:cNvCxnSpPr/>
          <p:nvPr/>
        </p:nvCxnSpPr>
        <p:spPr>
          <a:xfrm rot="5400000">
            <a:off x="3827197" y="756656"/>
            <a:ext cx="195608" cy="147964"/>
          </a:xfrm>
          <a:prstGeom prst="bentConnector2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꺾인 연결선 107"/>
          <p:cNvCxnSpPr/>
          <p:nvPr/>
        </p:nvCxnSpPr>
        <p:spPr>
          <a:xfrm rot="16200000" flipH="1">
            <a:off x="4027222" y="699506"/>
            <a:ext cx="195608" cy="147964"/>
          </a:xfrm>
          <a:prstGeom prst="bentConnector2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3390475" y="804473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4129580" y="736891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388968" y="3382838"/>
            <a:ext cx="70083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Hind III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7" name="직선 연결선 216"/>
          <p:cNvCxnSpPr/>
          <p:nvPr/>
        </p:nvCxnSpPr>
        <p:spPr>
          <a:xfrm>
            <a:off x="3408785" y="4104233"/>
            <a:ext cx="54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오른쪽 화살표 221"/>
          <p:cNvSpPr/>
          <p:nvPr/>
        </p:nvSpPr>
        <p:spPr>
          <a:xfrm>
            <a:off x="6246588" y="3948846"/>
            <a:ext cx="62024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3" name="TextBox 222"/>
          <p:cNvSpPr txBox="1"/>
          <p:nvPr/>
        </p:nvSpPr>
        <p:spPr>
          <a:xfrm>
            <a:off x="6244453" y="3957770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35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오른쪽 화살표 230"/>
          <p:cNvSpPr/>
          <p:nvPr/>
        </p:nvSpPr>
        <p:spPr>
          <a:xfrm>
            <a:off x="6893698" y="3948846"/>
            <a:ext cx="84507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2" name="TextBox 231"/>
          <p:cNvSpPr txBox="1"/>
          <p:nvPr/>
        </p:nvSpPr>
        <p:spPr>
          <a:xfrm>
            <a:off x="7004046" y="3957770"/>
            <a:ext cx="5180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GU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오른쪽 화살표 239"/>
          <p:cNvSpPr/>
          <p:nvPr/>
        </p:nvSpPr>
        <p:spPr>
          <a:xfrm>
            <a:off x="7821555" y="3948846"/>
            <a:ext cx="494455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1" name="TextBox 240"/>
          <p:cNvSpPr txBox="1"/>
          <p:nvPr/>
        </p:nvSpPr>
        <p:spPr>
          <a:xfrm>
            <a:off x="7762177" y="3957770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NO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오른쪽 화살표 247"/>
          <p:cNvSpPr/>
          <p:nvPr/>
        </p:nvSpPr>
        <p:spPr>
          <a:xfrm>
            <a:off x="6095239" y="3967109"/>
            <a:ext cx="72000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50" name="직선 화살표 연결선 249"/>
          <p:cNvCxnSpPr/>
          <p:nvPr/>
        </p:nvCxnSpPr>
        <p:spPr>
          <a:xfrm flipV="1">
            <a:off x="6108053" y="3832459"/>
            <a:ext cx="0" cy="2470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TextBox 250"/>
          <p:cNvSpPr txBox="1"/>
          <p:nvPr/>
        </p:nvSpPr>
        <p:spPr>
          <a:xfrm>
            <a:off x="5868186" y="3630581"/>
            <a:ext cx="526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CS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Rectangle 12"/>
          <p:cNvSpPr/>
          <p:nvPr/>
        </p:nvSpPr>
        <p:spPr>
          <a:xfrm>
            <a:off x="8476180" y="3914859"/>
            <a:ext cx="153447" cy="408688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4" name="TextBox 253"/>
          <p:cNvSpPr txBox="1"/>
          <p:nvPr/>
        </p:nvSpPr>
        <p:spPr>
          <a:xfrm>
            <a:off x="3792816" y="433576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Rectangle 12"/>
          <p:cNvSpPr/>
          <p:nvPr/>
        </p:nvSpPr>
        <p:spPr>
          <a:xfrm>
            <a:off x="3892372" y="3887154"/>
            <a:ext cx="153447" cy="408688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6" name="오른쪽 화살표 255"/>
          <p:cNvSpPr/>
          <p:nvPr/>
        </p:nvSpPr>
        <p:spPr>
          <a:xfrm flipH="1">
            <a:off x="5379831" y="3957770"/>
            <a:ext cx="503951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57" name="오른쪽 화살표 256"/>
          <p:cNvSpPr/>
          <p:nvPr/>
        </p:nvSpPr>
        <p:spPr>
          <a:xfrm flipH="1">
            <a:off x="4597378" y="3957770"/>
            <a:ext cx="753008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8" name="오른쪽 화살표 257"/>
          <p:cNvSpPr/>
          <p:nvPr/>
        </p:nvSpPr>
        <p:spPr>
          <a:xfrm flipH="1">
            <a:off x="4131447" y="3957770"/>
            <a:ext cx="445028" cy="294846"/>
          </a:xfrm>
          <a:prstGeom prst="rightArrow">
            <a:avLst>
              <a:gd name="adj1" fmla="val 10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9" name="TextBox 258"/>
          <p:cNvSpPr txBox="1"/>
          <p:nvPr/>
        </p:nvSpPr>
        <p:spPr>
          <a:xfrm>
            <a:off x="5368043" y="3963549"/>
            <a:ext cx="542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35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4773099" y="3963548"/>
            <a:ext cx="530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Hyg</a:t>
            </a:r>
            <a:r>
              <a:rPr lang="en-US" altLang="ko-KR" sz="12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TextBox 260"/>
          <p:cNvSpPr txBox="1"/>
          <p:nvPr/>
        </p:nvSpPr>
        <p:spPr>
          <a:xfrm>
            <a:off x="4141218" y="3972199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t35S</a:t>
            </a:r>
            <a:endParaRPr lang="ko-KR" alt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/>
          <p:cNvSpPr txBox="1"/>
          <p:nvPr/>
        </p:nvSpPr>
        <p:spPr>
          <a:xfrm>
            <a:off x="8346083" y="437373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ko-KR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6" name="직선 화살표 연결선 265"/>
          <p:cNvCxnSpPr>
            <a:stCxn id="241" idx="3"/>
            <a:endCxn id="83" idx="3"/>
          </p:cNvCxnSpPr>
          <p:nvPr/>
        </p:nvCxnSpPr>
        <p:spPr>
          <a:xfrm flipV="1">
            <a:off x="8323549" y="2767566"/>
            <a:ext cx="487316" cy="1328704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headEnd type="diamond" w="med" len="med"/>
            <a:tailEnd type="diamond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/>
          <p:cNvSpPr txBox="1"/>
          <p:nvPr/>
        </p:nvSpPr>
        <p:spPr>
          <a:xfrm>
            <a:off x="2119369" y="3931957"/>
            <a:ext cx="158408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CAMBIA120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아래쪽 화살표 285"/>
          <p:cNvSpPr/>
          <p:nvPr/>
        </p:nvSpPr>
        <p:spPr>
          <a:xfrm>
            <a:off x="6888053" y="4679174"/>
            <a:ext cx="325260" cy="480374"/>
          </a:xfrm>
          <a:prstGeom prst="downArrow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0B5F9A29-C348-8F49-A5B9-68F29726F893}"/>
              </a:ext>
            </a:extLst>
          </p:cNvPr>
          <p:cNvGrpSpPr/>
          <p:nvPr/>
        </p:nvGrpSpPr>
        <p:grpSpPr>
          <a:xfrm>
            <a:off x="1870966" y="4919181"/>
            <a:ext cx="8746973" cy="1426654"/>
            <a:chOff x="1972040" y="5265237"/>
            <a:chExt cx="8746973" cy="1426654"/>
          </a:xfrm>
        </p:grpSpPr>
        <p:cxnSp>
          <p:nvCxnSpPr>
            <p:cNvPr id="141" name="직선 연결선 140"/>
            <p:cNvCxnSpPr/>
            <p:nvPr/>
          </p:nvCxnSpPr>
          <p:spPr>
            <a:xfrm flipV="1">
              <a:off x="2375844" y="6136394"/>
              <a:ext cx="82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2" name="오른쪽 화살표 141"/>
            <p:cNvSpPr/>
            <p:nvPr/>
          </p:nvSpPr>
          <p:spPr>
            <a:xfrm>
              <a:off x="4728363" y="5988971"/>
              <a:ext cx="620245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666116" y="5997895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OsU3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오른쪽 화살표 143"/>
            <p:cNvSpPr/>
            <p:nvPr/>
          </p:nvSpPr>
          <p:spPr>
            <a:xfrm>
              <a:off x="5379455" y="5988971"/>
              <a:ext cx="126560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878817" y="6319180"/>
              <a:ext cx="11599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gRNA scaffold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오른쪽 화살표 145"/>
            <p:cNvSpPr/>
            <p:nvPr/>
          </p:nvSpPr>
          <p:spPr>
            <a:xfrm>
              <a:off x="6052682" y="5988971"/>
              <a:ext cx="620245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6050547" y="5997895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35S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오른쪽 화살표 147"/>
            <p:cNvSpPr/>
            <p:nvPr/>
          </p:nvSpPr>
          <p:spPr>
            <a:xfrm>
              <a:off x="6685327" y="5988971"/>
              <a:ext cx="72000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9" name="오른쪽 화살표 148"/>
            <p:cNvSpPr/>
            <p:nvPr/>
          </p:nvSpPr>
          <p:spPr>
            <a:xfrm>
              <a:off x="6776830" y="5988971"/>
              <a:ext cx="7910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0" name="오른쪽 화살표 149"/>
            <p:cNvSpPr/>
            <p:nvPr/>
          </p:nvSpPr>
          <p:spPr>
            <a:xfrm>
              <a:off x="6881186" y="5988971"/>
              <a:ext cx="7910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6138564" y="6319180"/>
              <a:ext cx="5437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attB1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꺾인 연결선 151"/>
            <p:cNvCxnSpPr/>
            <p:nvPr/>
          </p:nvCxnSpPr>
          <p:spPr>
            <a:xfrm rot="5400000">
              <a:off x="6570250" y="6280291"/>
              <a:ext cx="140558" cy="128644"/>
            </a:xfrm>
            <a:prstGeom prst="bentConnector3">
              <a:avLst>
                <a:gd name="adj1" fmla="val 102747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TextBox 152"/>
            <p:cNvSpPr txBox="1"/>
            <p:nvPr/>
          </p:nvSpPr>
          <p:spPr>
            <a:xfrm>
              <a:off x="6945008" y="6319180"/>
              <a:ext cx="9012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V40 NLS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4" name="꺾인 연결선 153"/>
            <p:cNvCxnSpPr/>
            <p:nvPr/>
          </p:nvCxnSpPr>
          <p:spPr>
            <a:xfrm rot="16200000" flipH="1">
              <a:off x="6895648" y="6284409"/>
              <a:ext cx="140558" cy="128644"/>
            </a:xfrm>
            <a:prstGeom prst="bentConnector3">
              <a:avLst>
                <a:gd name="adj1" fmla="val 102747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오른쪽 화살표 154"/>
            <p:cNvSpPr/>
            <p:nvPr/>
          </p:nvSpPr>
          <p:spPr>
            <a:xfrm>
              <a:off x="6985542" y="5988971"/>
              <a:ext cx="224095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7533017" y="5997895"/>
              <a:ext cx="7296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SpCas9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오른쪽 화살표 156"/>
            <p:cNvSpPr/>
            <p:nvPr/>
          </p:nvSpPr>
          <p:spPr>
            <a:xfrm>
              <a:off x="9240819" y="5988971"/>
              <a:ext cx="7910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8353600" y="6319180"/>
              <a:ext cx="8675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NPM NLS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9" name="꺾인 연결선 158"/>
            <p:cNvCxnSpPr/>
            <p:nvPr/>
          </p:nvCxnSpPr>
          <p:spPr>
            <a:xfrm rot="5400000">
              <a:off x="9129670" y="6292389"/>
              <a:ext cx="140558" cy="128644"/>
            </a:xfrm>
            <a:prstGeom prst="bentConnector3">
              <a:avLst>
                <a:gd name="adj1" fmla="val 102747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오른쪽 화살표 159"/>
            <p:cNvSpPr/>
            <p:nvPr/>
          </p:nvSpPr>
          <p:spPr>
            <a:xfrm flipH="1">
              <a:off x="9378339" y="5988971"/>
              <a:ext cx="72000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9479308" y="6319180"/>
              <a:ext cx="5437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attB2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2" name="꺾인 연결선 161"/>
            <p:cNvCxnSpPr/>
            <p:nvPr/>
          </p:nvCxnSpPr>
          <p:spPr>
            <a:xfrm rot="16200000" flipH="1">
              <a:off x="9414689" y="6306239"/>
              <a:ext cx="140558" cy="128644"/>
            </a:xfrm>
            <a:prstGeom prst="bentConnector3">
              <a:avLst>
                <a:gd name="adj1" fmla="val 102747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오른쪽 화살표 162"/>
            <p:cNvSpPr/>
            <p:nvPr/>
          </p:nvSpPr>
          <p:spPr>
            <a:xfrm>
              <a:off x="9471242" y="5988971"/>
              <a:ext cx="7910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4" name="오른쪽 화살표 163"/>
            <p:cNvSpPr/>
            <p:nvPr/>
          </p:nvSpPr>
          <p:spPr>
            <a:xfrm>
              <a:off x="9589799" y="5988971"/>
              <a:ext cx="494455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9530421" y="5997895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NOS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꺾인 연결선 165"/>
            <p:cNvCxnSpPr>
              <a:stCxn id="149" idx="0"/>
            </p:cNvCxnSpPr>
            <p:nvPr/>
          </p:nvCxnSpPr>
          <p:spPr>
            <a:xfrm rot="5400000" flipH="1" flipV="1">
              <a:off x="6792559" y="5817185"/>
              <a:ext cx="195608" cy="147964"/>
            </a:xfrm>
            <a:prstGeom prst="bentConnector2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/>
            <p:cNvSpPr txBox="1"/>
            <p:nvPr/>
          </p:nvSpPr>
          <p:spPr>
            <a:xfrm>
              <a:off x="6873887" y="5646402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3xFLAG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꺾인 연결선 168"/>
            <p:cNvCxnSpPr/>
            <p:nvPr/>
          </p:nvCxnSpPr>
          <p:spPr>
            <a:xfrm rot="16200000" flipV="1">
              <a:off x="9403566" y="5901340"/>
              <a:ext cx="166924" cy="2175"/>
            </a:xfrm>
            <a:prstGeom prst="bentConnector3">
              <a:avLst>
                <a:gd name="adj1" fmla="val 5000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TextBox 170"/>
            <p:cNvSpPr txBox="1"/>
            <p:nvPr/>
          </p:nvSpPr>
          <p:spPr>
            <a:xfrm>
              <a:off x="9131926" y="5636877"/>
              <a:ext cx="587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오른쪽 화살표 171"/>
            <p:cNvSpPr/>
            <p:nvPr/>
          </p:nvSpPr>
          <p:spPr>
            <a:xfrm>
              <a:off x="5329795" y="5988971"/>
              <a:ext cx="72000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73" name="직선 화살표 연결선 172"/>
            <p:cNvCxnSpPr/>
            <p:nvPr/>
          </p:nvCxnSpPr>
          <p:spPr>
            <a:xfrm>
              <a:off x="5450379" y="6150824"/>
              <a:ext cx="0" cy="2470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직선 화살표 연결선 173"/>
            <p:cNvCxnSpPr/>
            <p:nvPr/>
          </p:nvCxnSpPr>
          <p:spPr>
            <a:xfrm flipV="1">
              <a:off x="5342609" y="5854321"/>
              <a:ext cx="0" cy="24702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/>
            <p:cNvSpPr txBox="1"/>
            <p:nvPr/>
          </p:nvSpPr>
          <p:spPr>
            <a:xfrm>
              <a:off x="4770537" y="5265237"/>
              <a:ext cx="106311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  <a:r>
                <a:rPr lang="en-US" altLang="ko-K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C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ko-K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luB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altLang="ko-K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gRNA-GluA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Rectangle 12"/>
            <p:cNvSpPr/>
            <p:nvPr/>
          </p:nvSpPr>
          <p:spPr>
            <a:xfrm>
              <a:off x="10244424" y="5954984"/>
              <a:ext cx="153447" cy="4086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0321148" y="6414892"/>
              <a:ext cx="397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RB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2436860" y="6375894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LB</a:t>
              </a:r>
              <a:endParaRPr lang="ko-KR" alt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Rectangle 12"/>
            <p:cNvSpPr/>
            <p:nvPr/>
          </p:nvSpPr>
          <p:spPr>
            <a:xfrm>
              <a:off x="2536416" y="5927279"/>
              <a:ext cx="153447" cy="40868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0" name="오른쪽 화살표 179"/>
            <p:cNvSpPr/>
            <p:nvPr/>
          </p:nvSpPr>
          <p:spPr>
            <a:xfrm flipH="1">
              <a:off x="4023875" y="5997895"/>
              <a:ext cx="503951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81" name="오른쪽 화살표 180"/>
            <p:cNvSpPr/>
            <p:nvPr/>
          </p:nvSpPr>
          <p:spPr>
            <a:xfrm flipH="1">
              <a:off x="3241422" y="5997895"/>
              <a:ext cx="753008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3" name="오른쪽 화살표 182"/>
            <p:cNvSpPr/>
            <p:nvPr/>
          </p:nvSpPr>
          <p:spPr>
            <a:xfrm flipH="1">
              <a:off x="2775491" y="5997895"/>
              <a:ext cx="445028" cy="294846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4012087" y="6022724"/>
              <a:ext cx="542135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35S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3417143" y="6003673"/>
              <a:ext cx="5309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yg</a:t>
              </a:r>
              <a:r>
                <a:rPr lang="en-US" altLang="ko-KR" sz="1200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2785262" y="6012324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t35S</a:t>
              </a:r>
              <a:endParaRPr lang="ko-KR" altLang="en-US" sz="12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4125938" y="5348586"/>
              <a:ext cx="70083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nd III</a:t>
              </a:r>
              <a:endParaRPr lang="ko-KR" alt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9678242" y="5348586"/>
              <a:ext cx="68961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stE</a:t>
              </a:r>
              <a:r>
                <a:rPr lang="en-US" altLang="ko-K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II</a:t>
              </a:r>
              <a:endParaRPr lang="ko-KR" alt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7" name="직선 화살표 연결선 286"/>
            <p:cNvCxnSpPr/>
            <p:nvPr/>
          </p:nvCxnSpPr>
          <p:spPr>
            <a:xfrm flipH="1" flipV="1">
              <a:off x="9994473" y="5625585"/>
              <a:ext cx="90516" cy="500211"/>
            </a:xfrm>
            <a:prstGeom prst="straightConnector1">
              <a:avLst/>
            </a:prstGeom>
            <a:ln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직선 화살표 연결선 288"/>
            <p:cNvCxnSpPr/>
            <p:nvPr/>
          </p:nvCxnSpPr>
          <p:spPr>
            <a:xfrm flipH="1" flipV="1">
              <a:off x="4593340" y="5625585"/>
              <a:ext cx="90516" cy="500211"/>
            </a:xfrm>
            <a:prstGeom prst="straightConnector1">
              <a:avLst/>
            </a:prstGeom>
            <a:ln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Box 289"/>
            <p:cNvSpPr txBox="1"/>
            <p:nvPr/>
          </p:nvSpPr>
          <p:spPr>
            <a:xfrm>
              <a:off x="1972040" y="5317808"/>
              <a:ext cx="168668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CAMBIA-Cas9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8208097" y="3344243"/>
            <a:ext cx="68961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BstE</a:t>
            </a:r>
            <a:r>
              <a:rPr lang="en-US" altLang="ko-KR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  <a:endParaRPr lang="ko-KR" alt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19369" y="437456"/>
            <a:ext cx="981359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RGE3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FF0611-0FE3-31B6-2B8B-5A175EE9D2FE}"/>
              </a:ext>
            </a:extLst>
          </p:cNvPr>
          <p:cNvSpPr txBox="1"/>
          <p:nvPr/>
        </p:nvSpPr>
        <p:spPr>
          <a:xfrm>
            <a:off x="2119369" y="6511131"/>
            <a:ext cx="93741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Construction of a CRISPR/Cas9 binary vector to edit the rice glutelin genes. </a:t>
            </a:r>
          </a:p>
        </p:txBody>
      </p:sp>
    </p:spTree>
    <p:extLst>
      <p:ext uri="{BB962C8B-B14F-4D97-AF65-F5344CB8AC3E}">
        <p14:creationId xmlns:p14="http://schemas.microsoft.com/office/powerpoint/2010/main" val="2543189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tangle 1">
            <a:extLst>
              <a:ext uri="{FF2B5EF4-FFF2-40B4-BE49-F238E27FC236}">
                <a16:creationId xmlns:a16="http://schemas.microsoft.com/office/drawing/2014/main" id="{30DF7AD5-2DE0-93BF-5FC4-C837F27AF2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105" y="764673"/>
            <a:ext cx="2422956" cy="8872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</a:t>
            </a:r>
            <a:r>
              <a:rPr lang="en-US" altLang="ko-KR" sz="1000" b="1" dirty="0"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--------</a:t>
            </a:r>
            <a:r>
              <a:rPr kumimoji="0" lang="en-US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--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en-US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  <a:ea typeface="SimSun-ExtB" panose="02010609060101010101"/>
              </a:rPr>
              <a:t>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GCAAA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</a:t>
            </a:r>
            <a:r>
              <a:rPr kumimoji="0" lang="ko-KR" altLang="ko-KR" sz="1000" b="1" i="0" u="none" strike="noStrike" cap="none" normalizeH="0" baseline="0" dirty="0" err="1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A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</a:t>
            </a:r>
            <a:endParaRPr lang="en-US" altLang="ko-KR" sz="1000" dirty="0">
              <a:solidFill>
                <a:srgbClr val="222222"/>
              </a:solidFill>
              <a:latin typeface="SimSun-ExtB" panose="02010609060101010101" pitchFamily="49" charset="-122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9FDD2A9-2D28-67F8-62AE-8B669B22F818}"/>
              </a:ext>
            </a:extLst>
          </p:cNvPr>
          <p:cNvSpPr txBox="1"/>
          <p:nvPr/>
        </p:nvSpPr>
        <p:spPr>
          <a:xfrm>
            <a:off x="264722" y="715628"/>
            <a:ext cx="463652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a -</a:t>
            </a:r>
          </a:p>
          <a:p>
            <a:pPr algn="r"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a 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1D8F62AA-7155-1AAF-0D50-89D328CF8F81}"/>
              </a:ext>
            </a:extLst>
          </p:cNvPr>
          <p:cNvCxnSpPr>
            <a:cxnSpLocks/>
          </p:cNvCxnSpPr>
          <p:nvPr/>
        </p:nvCxnSpPr>
        <p:spPr>
          <a:xfrm>
            <a:off x="285710" y="516723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직사각형 76">
            <a:extLst>
              <a:ext uri="{FF2B5EF4-FFF2-40B4-BE49-F238E27FC236}">
                <a16:creationId xmlns:a16="http://schemas.microsoft.com/office/drawing/2014/main" id="{F5665F5C-60B8-2872-6E43-2A5E63730575}"/>
              </a:ext>
            </a:extLst>
          </p:cNvPr>
          <p:cNvSpPr/>
          <p:nvPr/>
        </p:nvSpPr>
        <p:spPr>
          <a:xfrm>
            <a:off x="267524" y="269099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8" name="직사각형 77">
            <a:extLst>
              <a:ext uri="{FF2B5EF4-FFF2-40B4-BE49-F238E27FC236}">
                <a16:creationId xmlns:a16="http://schemas.microsoft.com/office/drawing/2014/main" id="{6958D8F4-8C6C-5504-7EB4-A16CF7D9B737}"/>
              </a:ext>
            </a:extLst>
          </p:cNvPr>
          <p:cNvSpPr/>
          <p:nvPr/>
        </p:nvSpPr>
        <p:spPr>
          <a:xfrm>
            <a:off x="1187298" y="269099"/>
            <a:ext cx="13308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-1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3450D311-497F-E80B-2B7B-F8A7BC8F38F4}"/>
              </a:ext>
            </a:extLst>
          </p:cNvPr>
          <p:cNvCxnSpPr>
            <a:cxnSpLocks/>
          </p:cNvCxnSpPr>
          <p:nvPr/>
        </p:nvCxnSpPr>
        <p:spPr>
          <a:xfrm>
            <a:off x="822815" y="516724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E7B6D3B4-528C-BD71-0712-1A983C9766EB}"/>
              </a:ext>
            </a:extLst>
          </p:cNvPr>
          <p:cNvSpPr txBox="1"/>
          <p:nvPr/>
        </p:nvSpPr>
        <p:spPr>
          <a:xfrm>
            <a:off x="3040306" y="731196"/>
            <a:ext cx="771365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 &amp; Sub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73792C4-CE0E-D713-B67D-E2A7EB7151AE}"/>
              </a:ext>
            </a:extLst>
          </p:cNvPr>
          <p:cNvSpPr txBox="1"/>
          <p:nvPr/>
        </p:nvSpPr>
        <p:spPr>
          <a:xfrm>
            <a:off x="3783114" y="950271"/>
            <a:ext cx="615874" cy="7562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2.59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7.03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4.04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54B9444F-EDD7-E093-72D0-CF8EB13D62B3}"/>
              </a:ext>
            </a:extLst>
          </p:cNvPr>
          <p:cNvCxnSpPr>
            <a:cxnSpLocks/>
          </p:cNvCxnSpPr>
          <p:nvPr/>
        </p:nvCxnSpPr>
        <p:spPr>
          <a:xfrm>
            <a:off x="3113765" y="526248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6A72626A-C538-9337-7493-8DAC7061C50B}"/>
              </a:ext>
            </a:extLst>
          </p:cNvPr>
          <p:cNvCxnSpPr>
            <a:cxnSpLocks/>
          </p:cNvCxnSpPr>
          <p:nvPr/>
        </p:nvCxnSpPr>
        <p:spPr>
          <a:xfrm>
            <a:off x="3805774" y="526248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직사각형 83">
            <a:extLst>
              <a:ext uri="{FF2B5EF4-FFF2-40B4-BE49-F238E27FC236}">
                <a16:creationId xmlns:a16="http://schemas.microsoft.com/office/drawing/2014/main" id="{3D5F9626-5535-835A-84A2-4611B021F778}"/>
              </a:ext>
            </a:extLst>
          </p:cNvPr>
          <p:cNvSpPr/>
          <p:nvPr/>
        </p:nvSpPr>
        <p:spPr>
          <a:xfrm>
            <a:off x="3126464" y="278624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341CDFD7-8CF1-D24A-655E-1575B0EBCA4D}"/>
              </a:ext>
            </a:extLst>
          </p:cNvPr>
          <p:cNvSpPr/>
          <p:nvPr/>
        </p:nvSpPr>
        <p:spPr>
          <a:xfrm>
            <a:off x="3729574" y="278624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6" name="Rectangle 1">
            <a:extLst>
              <a:ext uri="{FF2B5EF4-FFF2-40B4-BE49-F238E27FC236}">
                <a16:creationId xmlns:a16="http://schemas.microsoft.com/office/drawing/2014/main" id="{E72D54A2-7CD5-ED70-FE62-19896D949E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0693" y="764673"/>
            <a:ext cx="2268497" cy="8872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</a:t>
            </a:r>
            <a:r>
              <a:rPr kumimoji="0" lang="en-US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</p:txBody>
      </p:sp>
      <p:sp>
        <p:nvSpPr>
          <p:cNvPr id="87" name="직사각형 86">
            <a:extLst>
              <a:ext uri="{FF2B5EF4-FFF2-40B4-BE49-F238E27FC236}">
                <a16:creationId xmlns:a16="http://schemas.microsoft.com/office/drawing/2014/main" id="{B811CA52-0C0F-D2FC-5319-52081E6EEDBB}"/>
              </a:ext>
            </a:extLst>
          </p:cNvPr>
          <p:cNvSpPr/>
          <p:nvPr/>
        </p:nvSpPr>
        <p:spPr>
          <a:xfrm>
            <a:off x="5406058" y="269099"/>
            <a:ext cx="13308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-2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CEA42F41-DF45-8364-5692-6139DE21C9A4}"/>
              </a:ext>
            </a:extLst>
          </p:cNvPr>
          <p:cNvCxnSpPr>
            <a:cxnSpLocks/>
          </p:cNvCxnSpPr>
          <p:nvPr/>
        </p:nvCxnSpPr>
        <p:spPr>
          <a:xfrm>
            <a:off x="4822500" y="516724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D76B148A-3966-0E46-F21F-50581D552724}"/>
              </a:ext>
            </a:extLst>
          </p:cNvPr>
          <p:cNvSpPr txBox="1"/>
          <p:nvPr/>
        </p:nvSpPr>
        <p:spPr>
          <a:xfrm>
            <a:off x="7014645" y="731196"/>
            <a:ext cx="420308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FD8FA2A-8AE6-A97C-5A3C-9DE8EEBD797E}"/>
              </a:ext>
            </a:extLst>
          </p:cNvPr>
          <p:cNvSpPr txBox="1"/>
          <p:nvPr/>
        </p:nvSpPr>
        <p:spPr>
          <a:xfrm>
            <a:off x="7430425" y="940746"/>
            <a:ext cx="615874" cy="7562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3%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3%</a:t>
            </a:r>
          </a:p>
        </p:txBody>
      </p: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2A9E4EFD-DF8E-5403-E6BE-8967B4CC1239}"/>
              </a:ext>
            </a:extLst>
          </p:cNvPr>
          <p:cNvCxnSpPr>
            <a:cxnSpLocks/>
          </p:cNvCxnSpPr>
          <p:nvPr/>
        </p:nvCxnSpPr>
        <p:spPr>
          <a:xfrm>
            <a:off x="7056300" y="516723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9A43F5CE-E1DA-EF1F-4C61-295F66F75D68}"/>
              </a:ext>
            </a:extLst>
          </p:cNvPr>
          <p:cNvCxnSpPr>
            <a:cxnSpLocks/>
          </p:cNvCxnSpPr>
          <p:nvPr/>
        </p:nvCxnSpPr>
        <p:spPr>
          <a:xfrm>
            <a:off x="7487575" y="516723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직사각형 92">
            <a:extLst>
              <a:ext uri="{FF2B5EF4-FFF2-40B4-BE49-F238E27FC236}">
                <a16:creationId xmlns:a16="http://schemas.microsoft.com/office/drawing/2014/main" id="{79C386C5-BF22-B92E-6239-72E862F841A1}"/>
              </a:ext>
            </a:extLst>
          </p:cNvPr>
          <p:cNvSpPr/>
          <p:nvPr/>
        </p:nvSpPr>
        <p:spPr>
          <a:xfrm>
            <a:off x="7014645" y="269099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4" name="직사각형 93">
            <a:extLst>
              <a:ext uri="{FF2B5EF4-FFF2-40B4-BE49-F238E27FC236}">
                <a16:creationId xmlns:a16="http://schemas.microsoft.com/office/drawing/2014/main" id="{F449E778-A0FC-E2B9-02C0-515DB01413EE}"/>
              </a:ext>
            </a:extLst>
          </p:cNvPr>
          <p:cNvSpPr/>
          <p:nvPr/>
        </p:nvSpPr>
        <p:spPr>
          <a:xfrm>
            <a:off x="7430425" y="269099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5" name="Rectangle 1">
            <a:extLst>
              <a:ext uri="{FF2B5EF4-FFF2-40B4-BE49-F238E27FC236}">
                <a16:creationId xmlns:a16="http://schemas.microsoft.com/office/drawing/2014/main" id="{B936E30B-46CD-5B84-C6BF-EDF9EA773B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52469" y="764673"/>
            <a:ext cx="2268497" cy="8872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C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</a:t>
            </a:r>
            <a:r>
              <a:rPr lang="en-US" altLang="ko-KR" sz="1000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G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CGTGTATATTACTCA</a:t>
            </a:r>
            <a:r>
              <a:rPr lang="en-US" altLang="ko-KR" sz="1000" b="1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</p:txBody>
      </p:sp>
      <p:sp>
        <p:nvSpPr>
          <p:cNvPr id="96" name="직사각형 95">
            <a:extLst>
              <a:ext uri="{FF2B5EF4-FFF2-40B4-BE49-F238E27FC236}">
                <a16:creationId xmlns:a16="http://schemas.microsoft.com/office/drawing/2014/main" id="{1D7E46C7-B9D8-9959-05EC-2BB2F7769640}"/>
              </a:ext>
            </a:extLst>
          </p:cNvPr>
          <p:cNvSpPr/>
          <p:nvPr/>
        </p:nvSpPr>
        <p:spPr>
          <a:xfrm>
            <a:off x="9214509" y="269099"/>
            <a:ext cx="13308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-3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8B778A93-BC5D-A862-F820-73C22AB423B9}"/>
              </a:ext>
            </a:extLst>
          </p:cNvPr>
          <p:cNvCxnSpPr>
            <a:cxnSpLocks/>
          </p:cNvCxnSpPr>
          <p:nvPr/>
        </p:nvCxnSpPr>
        <p:spPr>
          <a:xfrm>
            <a:off x="8564276" y="516724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D9F3B44A-3F08-B045-AAFA-975E9D1D8FD7}"/>
              </a:ext>
            </a:extLst>
          </p:cNvPr>
          <p:cNvSpPr txBox="1"/>
          <p:nvPr/>
        </p:nvSpPr>
        <p:spPr>
          <a:xfrm>
            <a:off x="10746896" y="721671"/>
            <a:ext cx="420308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D8172B9-798E-6E05-8C00-2F2292508286}"/>
              </a:ext>
            </a:extLst>
          </p:cNvPr>
          <p:cNvSpPr txBox="1"/>
          <p:nvPr/>
        </p:nvSpPr>
        <p:spPr>
          <a:xfrm>
            <a:off x="11200326" y="940746"/>
            <a:ext cx="615874" cy="7562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8.84%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8.89%</a:t>
            </a:r>
          </a:p>
        </p:txBody>
      </p: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id="{D0D1CD57-3C2D-BF90-76AE-EE03127A2C03}"/>
              </a:ext>
            </a:extLst>
          </p:cNvPr>
          <p:cNvCxnSpPr>
            <a:cxnSpLocks/>
          </p:cNvCxnSpPr>
          <p:nvPr/>
        </p:nvCxnSpPr>
        <p:spPr>
          <a:xfrm>
            <a:off x="10788551" y="516723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0838ECDB-2756-6269-E52F-E85B2A46ECC0}"/>
              </a:ext>
            </a:extLst>
          </p:cNvPr>
          <p:cNvCxnSpPr>
            <a:cxnSpLocks/>
          </p:cNvCxnSpPr>
          <p:nvPr/>
        </p:nvCxnSpPr>
        <p:spPr>
          <a:xfrm>
            <a:off x="11257926" y="516723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직사각형 101">
            <a:extLst>
              <a:ext uri="{FF2B5EF4-FFF2-40B4-BE49-F238E27FC236}">
                <a16:creationId xmlns:a16="http://schemas.microsoft.com/office/drawing/2014/main" id="{5A262B9C-E920-EC3A-B504-31EB9EE5780D}"/>
              </a:ext>
            </a:extLst>
          </p:cNvPr>
          <p:cNvSpPr/>
          <p:nvPr/>
        </p:nvSpPr>
        <p:spPr>
          <a:xfrm>
            <a:off x="10746896" y="269099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03" name="직사각형 102">
            <a:extLst>
              <a:ext uri="{FF2B5EF4-FFF2-40B4-BE49-F238E27FC236}">
                <a16:creationId xmlns:a16="http://schemas.microsoft.com/office/drawing/2014/main" id="{C60EA97F-4F08-CB94-E7B7-C110F7B0CCBD}"/>
              </a:ext>
            </a:extLst>
          </p:cNvPr>
          <p:cNvSpPr/>
          <p:nvPr/>
        </p:nvSpPr>
        <p:spPr>
          <a:xfrm>
            <a:off x="11200326" y="269099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EF43A8EB-5C08-9769-AC6B-BA51243E8D3C}"/>
              </a:ext>
            </a:extLst>
          </p:cNvPr>
          <p:cNvSpPr/>
          <p:nvPr/>
        </p:nvSpPr>
        <p:spPr>
          <a:xfrm>
            <a:off x="204279" y="46748"/>
            <a:ext cx="11783442" cy="17256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EFC252B-EBFE-1652-24CD-0FFFD400D405}"/>
              </a:ext>
            </a:extLst>
          </p:cNvPr>
          <p:cNvSpPr txBox="1"/>
          <p:nvPr/>
        </p:nvSpPr>
        <p:spPr>
          <a:xfrm>
            <a:off x="2568795" y="59444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FF9DDA87-08A5-F3D6-2902-E116A216F16E}"/>
              </a:ext>
            </a:extLst>
          </p:cNvPr>
          <p:cNvSpPr txBox="1"/>
          <p:nvPr/>
        </p:nvSpPr>
        <p:spPr>
          <a:xfrm>
            <a:off x="1398764" y="594441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4914651-7309-FE71-E30F-5C3BC626F448}"/>
              </a:ext>
            </a:extLst>
          </p:cNvPr>
          <p:cNvSpPr txBox="1"/>
          <p:nvPr/>
        </p:nvSpPr>
        <p:spPr>
          <a:xfrm>
            <a:off x="6581643" y="59444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B038B1EB-FFCD-1017-8D2C-C35DD4F064F7}"/>
              </a:ext>
            </a:extLst>
          </p:cNvPr>
          <p:cNvSpPr txBox="1"/>
          <p:nvPr/>
        </p:nvSpPr>
        <p:spPr>
          <a:xfrm>
            <a:off x="5440187" y="594441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E8BB272-8FFE-57F3-A1DA-00BDB49B1642}"/>
              </a:ext>
            </a:extLst>
          </p:cNvPr>
          <p:cNvSpPr txBox="1"/>
          <p:nvPr/>
        </p:nvSpPr>
        <p:spPr>
          <a:xfrm>
            <a:off x="10292951" y="59444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BE106B47-2002-C6D6-EB14-88FBE3FBEBA2}"/>
              </a:ext>
            </a:extLst>
          </p:cNvPr>
          <p:cNvSpPr txBox="1"/>
          <p:nvPr/>
        </p:nvSpPr>
        <p:spPr>
          <a:xfrm>
            <a:off x="9151495" y="594441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11" name="Rectangle 1">
            <a:extLst>
              <a:ext uri="{FF2B5EF4-FFF2-40B4-BE49-F238E27FC236}">
                <a16:creationId xmlns:a16="http://schemas.microsoft.com/office/drawing/2014/main" id="{0D6EAF7B-E3C2-C45C-FD50-8A22159A57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5848" y="2909886"/>
            <a:ext cx="2303868" cy="300082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G</a:t>
            </a:r>
            <a:endParaRPr lang="ko-KR" altLang="en-US" sz="1000" dirty="0">
              <a:latin typeface="SimSun-ExtB" panose="02010609060101010101" pitchFamily="49" charset="-122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GB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GB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</p:txBody>
      </p: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A2ABFC50-4CAB-AA97-23F2-18DC9C3F722B}"/>
              </a:ext>
            </a:extLst>
          </p:cNvPr>
          <p:cNvCxnSpPr/>
          <p:nvPr/>
        </p:nvCxnSpPr>
        <p:spPr>
          <a:xfrm>
            <a:off x="238918" y="2661190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1600D29D-B942-6369-AF26-E88200985DDF}"/>
              </a:ext>
            </a:extLst>
          </p:cNvPr>
          <p:cNvSpPr/>
          <p:nvPr/>
        </p:nvSpPr>
        <p:spPr>
          <a:xfrm>
            <a:off x="220732" y="2413566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91F3D855-BCF3-68AD-0767-81127E2FE9FD}"/>
              </a:ext>
            </a:extLst>
          </p:cNvPr>
          <p:cNvSpPr/>
          <p:nvPr/>
        </p:nvSpPr>
        <p:spPr>
          <a:xfrm>
            <a:off x="992242" y="2405202"/>
            <a:ext cx="150714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-1a/b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7E438B27-87A8-B7AC-A899-283A0670733F}"/>
              </a:ext>
            </a:extLst>
          </p:cNvPr>
          <p:cNvCxnSpPr/>
          <p:nvPr/>
        </p:nvCxnSpPr>
        <p:spPr>
          <a:xfrm>
            <a:off x="696907" y="2661190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AB4757C5-634A-B973-C272-620FA7C62383}"/>
              </a:ext>
            </a:extLst>
          </p:cNvPr>
          <p:cNvCxnSpPr/>
          <p:nvPr/>
        </p:nvCxnSpPr>
        <p:spPr>
          <a:xfrm>
            <a:off x="2958508" y="2661190"/>
            <a:ext cx="252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id="{31A25D19-BEBF-24E7-529F-9EE7EFB8C8D1}"/>
              </a:ext>
            </a:extLst>
          </p:cNvPr>
          <p:cNvCxnSpPr/>
          <p:nvPr/>
        </p:nvCxnSpPr>
        <p:spPr>
          <a:xfrm>
            <a:off x="3288567" y="2661190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직사각형 117">
            <a:extLst>
              <a:ext uri="{FF2B5EF4-FFF2-40B4-BE49-F238E27FC236}">
                <a16:creationId xmlns:a16="http://schemas.microsoft.com/office/drawing/2014/main" id="{69E6DC07-AFE7-B4F9-B5A0-BCCD8B9D177E}"/>
              </a:ext>
            </a:extLst>
          </p:cNvPr>
          <p:cNvSpPr/>
          <p:nvPr/>
        </p:nvSpPr>
        <p:spPr>
          <a:xfrm>
            <a:off x="2856907" y="2413566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19" name="직사각형 118">
            <a:extLst>
              <a:ext uri="{FF2B5EF4-FFF2-40B4-BE49-F238E27FC236}">
                <a16:creationId xmlns:a16="http://schemas.microsoft.com/office/drawing/2014/main" id="{E784B132-7A20-B796-B00C-BEC9DCBBCB57}"/>
              </a:ext>
            </a:extLst>
          </p:cNvPr>
          <p:cNvSpPr/>
          <p:nvPr/>
        </p:nvSpPr>
        <p:spPr>
          <a:xfrm>
            <a:off x="3212367" y="2413566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D4F4E83-173E-E70E-6B55-56DEB6C60930}"/>
              </a:ext>
            </a:extLst>
          </p:cNvPr>
          <p:cNvSpPr txBox="1"/>
          <p:nvPr/>
        </p:nvSpPr>
        <p:spPr>
          <a:xfrm>
            <a:off x="2885761" y="3107392"/>
            <a:ext cx="385042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98B3B5B-64AA-C28A-1824-5CA955EB4B77}"/>
              </a:ext>
            </a:extLst>
          </p:cNvPr>
          <p:cNvSpPr txBox="1"/>
          <p:nvPr/>
        </p:nvSpPr>
        <p:spPr>
          <a:xfrm>
            <a:off x="3212367" y="2883116"/>
            <a:ext cx="615874" cy="309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7.82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45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48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45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4%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3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1%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41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8.64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28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6EA81B9F-24E8-4617-4AEB-213E107DDDAA}"/>
              </a:ext>
            </a:extLst>
          </p:cNvPr>
          <p:cNvSpPr txBox="1"/>
          <p:nvPr/>
        </p:nvSpPr>
        <p:spPr>
          <a:xfrm>
            <a:off x="209446" y="2865864"/>
            <a:ext cx="474874" cy="309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b –</a:t>
            </a:r>
          </a:p>
          <a:p>
            <a:pPr algn="r">
              <a:lnSpc>
                <a:spcPct val="150000"/>
              </a:lnSpc>
            </a:pP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b –</a:t>
            </a:r>
          </a:p>
          <a:p>
            <a:pPr algn="r"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8b 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b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b -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383CB6B-A409-3668-22A1-B184D6E6C63D}"/>
              </a:ext>
            </a:extLst>
          </p:cNvPr>
          <p:cNvSpPr txBox="1"/>
          <p:nvPr/>
        </p:nvSpPr>
        <p:spPr>
          <a:xfrm>
            <a:off x="2407524" y="269690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6A87B638-8F9D-1A47-53D9-738FFD79F810}"/>
              </a:ext>
            </a:extLst>
          </p:cNvPr>
          <p:cNvSpPr txBox="1"/>
          <p:nvPr/>
        </p:nvSpPr>
        <p:spPr>
          <a:xfrm>
            <a:off x="1237493" y="2696908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25" name="Rectangle 1">
            <a:extLst>
              <a:ext uri="{FF2B5EF4-FFF2-40B4-BE49-F238E27FC236}">
                <a16:creationId xmlns:a16="http://schemas.microsoft.com/office/drawing/2014/main" id="{493C3104-9D23-3B0E-8F1D-AF5BE2760E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24914" y="2918512"/>
            <a:ext cx="2303868" cy="300082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A</a:t>
            </a:r>
            <a:endParaRPr lang="ko-KR" altLang="en-US" sz="1000" dirty="0">
              <a:latin typeface="SimSun-ExtB" panose="02010609060101010101" pitchFamily="49" charset="-122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</a:t>
            </a:r>
            <a:r>
              <a:rPr kumimoji="0" lang="en-US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</a:t>
            </a:r>
            <a:r>
              <a:rPr kumimoji="0" lang="en-GB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</a:t>
            </a:r>
            <a:r>
              <a:rPr kumimoji="0" lang="en-GB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</a:t>
            </a:r>
            <a:r>
              <a:rPr kumimoji="0" lang="en-GB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T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-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-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</a:t>
            </a:r>
            <a:endParaRPr lang="en-US" altLang="ko-KR" sz="1000" dirty="0">
              <a:solidFill>
                <a:srgbClr val="222222"/>
              </a:solidFill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endParaRPr kumimoji="0" lang="en-GB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-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endParaRPr kumimoji="0" lang="en-GB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T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T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</a:p>
        </p:txBody>
      </p:sp>
      <p:sp>
        <p:nvSpPr>
          <p:cNvPr id="126" name="직사각형 125">
            <a:extLst>
              <a:ext uri="{FF2B5EF4-FFF2-40B4-BE49-F238E27FC236}">
                <a16:creationId xmlns:a16="http://schemas.microsoft.com/office/drawing/2014/main" id="{7DD3AB74-7FC4-F6E9-2916-955FEF3732A7}"/>
              </a:ext>
            </a:extLst>
          </p:cNvPr>
          <p:cNvSpPr/>
          <p:nvPr/>
        </p:nvSpPr>
        <p:spPr>
          <a:xfrm>
            <a:off x="4595133" y="2413566"/>
            <a:ext cx="133081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-2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F6E794E1-8D63-297C-41A5-577AE4BD147E}"/>
              </a:ext>
            </a:extLst>
          </p:cNvPr>
          <p:cNvCxnSpPr/>
          <p:nvPr/>
        </p:nvCxnSpPr>
        <p:spPr>
          <a:xfrm>
            <a:off x="4175973" y="2669554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D987CEFE-6042-5C0E-74B4-F9884408F112}"/>
              </a:ext>
            </a:extLst>
          </p:cNvPr>
          <p:cNvCxnSpPr/>
          <p:nvPr/>
        </p:nvCxnSpPr>
        <p:spPr>
          <a:xfrm>
            <a:off x="6437574" y="2669554"/>
            <a:ext cx="252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연결선 128">
            <a:extLst>
              <a:ext uri="{FF2B5EF4-FFF2-40B4-BE49-F238E27FC236}">
                <a16:creationId xmlns:a16="http://schemas.microsoft.com/office/drawing/2014/main" id="{228A3431-7BD9-110C-F6DE-00CF3CABBD33}"/>
              </a:ext>
            </a:extLst>
          </p:cNvPr>
          <p:cNvCxnSpPr/>
          <p:nvPr/>
        </p:nvCxnSpPr>
        <p:spPr>
          <a:xfrm>
            <a:off x="6767633" y="2669554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직사각형 129">
            <a:extLst>
              <a:ext uri="{FF2B5EF4-FFF2-40B4-BE49-F238E27FC236}">
                <a16:creationId xmlns:a16="http://schemas.microsoft.com/office/drawing/2014/main" id="{0CDFAC64-F831-6909-2408-0B5404A9BE67}"/>
              </a:ext>
            </a:extLst>
          </p:cNvPr>
          <p:cNvSpPr/>
          <p:nvPr/>
        </p:nvSpPr>
        <p:spPr>
          <a:xfrm>
            <a:off x="6335973" y="2421930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1" name="직사각형 130">
            <a:extLst>
              <a:ext uri="{FF2B5EF4-FFF2-40B4-BE49-F238E27FC236}">
                <a16:creationId xmlns:a16="http://schemas.microsoft.com/office/drawing/2014/main" id="{E5FDA041-C17F-2D80-A523-88630DC8997A}"/>
              </a:ext>
            </a:extLst>
          </p:cNvPr>
          <p:cNvSpPr/>
          <p:nvPr/>
        </p:nvSpPr>
        <p:spPr>
          <a:xfrm>
            <a:off x="6691433" y="2421930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C54BA4D-78B2-BD65-5B31-3E329874EB32}"/>
              </a:ext>
            </a:extLst>
          </p:cNvPr>
          <p:cNvSpPr txBox="1"/>
          <p:nvPr/>
        </p:nvSpPr>
        <p:spPr>
          <a:xfrm>
            <a:off x="6433835" y="2883116"/>
            <a:ext cx="385042" cy="309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D5CE6C01-5501-9253-8D79-904D173DC2BB}"/>
              </a:ext>
            </a:extLst>
          </p:cNvPr>
          <p:cNvSpPr txBox="1"/>
          <p:nvPr/>
        </p:nvSpPr>
        <p:spPr>
          <a:xfrm>
            <a:off x="6777693" y="2865864"/>
            <a:ext cx="615874" cy="30931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70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93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5.24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5.31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6.13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4.62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1.06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2.70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7.28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7.84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.29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8.29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634EF6F6-E224-7DD3-E58F-891EF7CD44ED}"/>
              </a:ext>
            </a:extLst>
          </p:cNvPr>
          <p:cNvSpPr txBox="1"/>
          <p:nvPr/>
        </p:nvSpPr>
        <p:spPr>
          <a:xfrm>
            <a:off x="5886590" y="269690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7EDA7660-1D45-A28A-E996-ADD1EF6B4A9A}"/>
              </a:ext>
            </a:extLst>
          </p:cNvPr>
          <p:cNvSpPr txBox="1"/>
          <p:nvPr/>
        </p:nvSpPr>
        <p:spPr>
          <a:xfrm>
            <a:off x="4716559" y="2696908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AD87A498-890B-374E-82B7-2E6746466368}"/>
              </a:ext>
            </a:extLst>
          </p:cNvPr>
          <p:cNvCxnSpPr/>
          <p:nvPr/>
        </p:nvCxnSpPr>
        <p:spPr>
          <a:xfrm>
            <a:off x="8093630" y="2684781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직사각형 136">
            <a:extLst>
              <a:ext uri="{FF2B5EF4-FFF2-40B4-BE49-F238E27FC236}">
                <a16:creationId xmlns:a16="http://schemas.microsoft.com/office/drawing/2014/main" id="{E23490F1-FF41-45F3-6C51-9049D06B89E0}"/>
              </a:ext>
            </a:extLst>
          </p:cNvPr>
          <p:cNvSpPr/>
          <p:nvPr/>
        </p:nvSpPr>
        <p:spPr>
          <a:xfrm>
            <a:off x="8075444" y="2437157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8" name="직사각형 137">
            <a:extLst>
              <a:ext uri="{FF2B5EF4-FFF2-40B4-BE49-F238E27FC236}">
                <a16:creationId xmlns:a16="http://schemas.microsoft.com/office/drawing/2014/main" id="{4B390F95-6C0A-3DF6-5716-DFA4C597DD73}"/>
              </a:ext>
            </a:extLst>
          </p:cNvPr>
          <p:cNvSpPr/>
          <p:nvPr/>
        </p:nvSpPr>
        <p:spPr>
          <a:xfrm>
            <a:off x="8846954" y="2428793"/>
            <a:ext cx="13388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equence of </a:t>
            </a:r>
            <a:r>
              <a:rPr lang="en-US" altLang="ko-KR" sz="1000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C-1</a:t>
            </a:r>
            <a:endParaRPr lang="ko-KR" altLang="en-US" sz="1000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39" name="직선 연결선 138">
            <a:extLst>
              <a:ext uri="{FF2B5EF4-FFF2-40B4-BE49-F238E27FC236}">
                <a16:creationId xmlns:a16="http://schemas.microsoft.com/office/drawing/2014/main" id="{A21D84AD-9C8A-BE63-6F44-7D9502505A01}"/>
              </a:ext>
            </a:extLst>
          </p:cNvPr>
          <p:cNvCxnSpPr/>
          <p:nvPr/>
        </p:nvCxnSpPr>
        <p:spPr>
          <a:xfrm>
            <a:off x="8551619" y="2684781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직선 연결선 139">
            <a:extLst>
              <a:ext uri="{FF2B5EF4-FFF2-40B4-BE49-F238E27FC236}">
                <a16:creationId xmlns:a16="http://schemas.microsoft.com/office/drawing/2014/main" id="{64C339CB-2F41-A483-1D14-E8AFB100E866}"/>
              </a:ext>
            </a:extLst>
          </p:cNvPr>
          <p:cNvCxnSpPr/>
          <p:nvPr/>
        </p:nvCxnSpPr>
        <p:spPr>
          <a:xfrm>
            <a:off x="10813220" y="2684781"/>
            <a:ext cx="252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직선 연결선 140">
            <a:extLst>
              <a:ext uri="{FF2B5EF4-FFF2-40B4-BE49-F238E27FC236}">
                <a16:creationId xmlns:a16="http://schemas.microsoft.com/office/drawing/2014/main" id="{60DE919A-D171-D84C-90E7-80D48AA5127F}"/>
              </a:ext>
            </a:extLst>
          </p:cNvPr>
          <p:cNvCxnSpPr/>
          <p:nvPr/>
        </p:nvCxnSpPr>
        <p:spPr>
          <a:xfrm>
            <a:off x="11143279" y="2684781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직사각형 141">
            <a:extLst>
              <a:ext uri="{FF2B5EF4-FFF2-40B4-BE49-F238E27FC236}">
                <a16:creationId xmlns:a16="http://schemas.microsoft.com/office/drawing/2014/main" id="{342586D9-DF87-1ED5-9A63-045A197E2131}"/>
              </a:ext>
            </a:extLst>
          </p:cNvPr>
          <p:cNvSpPr/>
          <p:nvPr/>
        </p:nvSpPr>
        <p:spPr>
          <a:xfrm>
            <a:off x="10711619" y="2437157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43" name="직사각형 142">
            <a:extLst>
              <a:ext uri="{FF2B5EF4-FFF2-40B4-BE49-F238E27FC236}">
                <a16:creationId xmlns:a16="http://schemas.microsoft.com/office/drawing/2014/main" id="{B43DB2F0-F5A3-5DE7-5EC2-0F0C3FDC0619}"/>
              </a:ext>
            </a:extLst>
          </p:cNvPr>
          <p:cNvSpPr/>
          <p:nvPr/>
        </p:nvSpPr>
        <p:spPr>
          <a:xfrm>
            <a:off x="11067079" y="2437157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49EBF58D-9165-6F58-1902-86234E0EFAEB}"/>
              </a:ext>
            </a:extLst>
          </p:cNvPr>
          <p:cNvSpPr txBox="1"/>
          <p:nvPr/>
        </p:nvSpPr>
        <p:spPr>
          <a:xfrm>
            <a:off x="10740473" y="2871566"/>
            <a:ext cx="385042" cy="5254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27D7EC33-F98B-9610-279A-FC888D50FC10}"/>
              </a:ext>
            </a:extLst>
          </p:cNvPr>
          <p:cNvSpPr txBox="1"/>
          <p:nvPr/>
        </p:nvSpPr>
        <p:spPr>
          <a:xfrm>
            <a:off x="11067079" y="2871566"/>
            <a:ext cx="615874" cy="5254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4.42%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C2BBB97B-07A8-6AF1-0FA3-27AD46AF3A1B}"/>
              </a:ext>
            </a:extLst>
          </p:cNvPr>
          <p:cNvSpPr txBox="1"/>
          <p:nvPr/>
        </p:nvSpPr>
        <p:spPr>
          <a:xfrm>
            <a:off x="8075444" y="2871566"/>
            <a:ext cx="463588" cy="5254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c -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C2AB83F3-C321-DA91-6583-8A64C038BF54}"/>
              </a:ext>
            </a:extLst>
          </p:cNvPr>
          <p:cNvSpPr txBox="1"/>
          <p:nvPr/>
        </p:nvSpPr>
        <p:spPr>
          <a:xfrm>
            <a:off x="10262236" y="2706432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7F1C156-E919-FD88-D1E4-D7867F24248C}"/>
              </a:ext>
            </a:extLst>
          </p:cNvPr>
          <p:cNvSpPr txBox="1"/>
          <p:nvPr/>
        </p:nvSpPr>
        <p:spPr>
          <a:xfrm>
            <a:off x="9092205" y="2706432"/>
            <a:ext cx="11400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BD2A989D-D2AF-38D9-2529-D90154817AD0}"/>
              </a:ext>
            </a:extLst>
          </p:cNvPr>
          <p:cNvSpPr txBox="1"/>
          <p:nvPr/>
        </p:nvSpPr>
        <p:spPr>
          <a:xfrm>
            <a:off x="8411775" y="2865305"/>
            <a:ext cx="245595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fontAlgn="ctr">
              <a:lnSpc>
                <a:spcPct val="150000"/>
              </a:lnSpc>
            </a:pPr>
            <a:r>
              <a:rPr lang="en-US" altLang="ko-KR" sz="1000" b="0" i="0" dirty="0">
                <a:solidFill>
                  <a:srgbClr val="00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CCATTTTCA</a:t>
            </a:r>
            <a:r>
              <a:rPr lang="en-US" altLang="ko-KR" sz="1000" b="1" i="0" dirty="0">
                <a:solidFill>
                  <a:srgbClr val="FF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ACTCTAATGATGGCACCTCT</a:t>
            </a:r>
            <a:r>
              <a:rPr lang="en-US" altLang="ko-KR" sz="1000" b="1" i="0" dirty="0">
                <a:solidFill>
                  <a:srgbClr val="00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TGG</a:t>
            </a:r>
            <a:r>
              <a:rPr lang="en-US" altLang="ko-KR" sz="1000" b="0" i="0" dirty="0">
                <a:solidFill>
                  <a:srgbClr val="00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GTC</a:t>
            </a:r>
          </a:p>
          <a:p>
            <a:pPr algn="l" fontAlgn="ctr">
              <a:lnSpc>
                <a:spcPct val="150000"/>
              </a:lnSpc>
            </a:pPr>
            <a:r>
              <a:rPr lang="en-US" altLang="ko-KR" sz="1000" dirty="0">
                <a:solidFill>
                  <a:srgbClr val="00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**********************</a:t>
            </a:r>
            <a:r>
              <a:rPr lang="en-US" altLang="ko-KR" sz="1000" b="1" dirty="0">
                <a:solidFill>
                  <a:srgbClr val="00B0F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----------</a:t>
            </a:r>
            <a:r>
              <a:rPr lang="en-US" altLang="ko-KR" sz="1000" dirty="0">
                <a:solidFill>
                  <a:srgbClr val="000000"/>
                </a:solidFill>
                <a:latin typeface="SimSun-ExtB" panose="02010609060101010101" pitchFamily="49" charset="-122"/>
                <a:ea typeface="SimSun-ExtB" panose="02010609060101010101" pitchFamily="49" charset="-122"/>
              </a:rPr>
              <a:t>***</a:t>
            </a:r>
            <a:endParaRPr lang="en-US" altLang="ko-KR" sz="1000" b="0" i="0" u="none" strike="noStrike" dirty="0">
              <a:solidFill>
                <a:srgbClr val="000000"/>
              </a:solidFill>
              <a:effectLst/>
              <a:latin typeface="SimSun-ExtB" panose="02010609060101010101" pitchFamily="49" charset="-122"/>
              <a:ea typeface="SimSun-ExtB" panose="02010609060101010101" pitchFamily="49" charset="-122"/>
            </a:endParaRPr>
          </a:p>
        </p:txBody>
      </p:sp>
      <p:sp>
        <p:nvSpPr>
          <p:cNvPr id="150" name="직사각형 149">
            <a:extLst>
              <a:ext uri="{FF2B5EF4-FFF2-40B4-BE49-F238E27FC236}">
                <a16:creationId xmlns:a16="http://schemas.microsoft.com/office/drawing/2014/main" id="{EEAB1229-B743-6BAE-9F3C-159B69333951}"/>
              </a:ext>
            </a:extLst>
          </p:cNvPr>
          <p:cNvSpPr/>
          <p:nvPr/>
        </p:nvSpPr>
        <p:spPr>
          <a:xfrm>
            <a:off x="7846680" y="2264800"/>
            <a:ext cx="4006467" cy="11545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1" name="직사각형 150">
            <a:extLst>
              <a:ext uri="{FF2B5EF4-FFF2-40B4-BE49-F238E27FC236}">
                <a16:creationId xmlns:a16="http://schemas.microsoft.com/office/drawing/2014/main" id="{618B3EE6-05F9-0318-271B-B7DFC45E55C3}"/>
              </a:ext>
            </a:extLst>
          </p:cNvPr>
          <p:cNvSpPr/>
          <p:nvPr/>
        </p:nvSpPr>
        <p:spPr>
          <a:xfrm>
            <a:off x="188522" y="2264800"/>
            <a:ext cx="7407175" cy="386860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" name="직사각형 1"/>
          <p:cNvSpPr/>
          <p:nvPr/>
        </p:nvSpPr>
        <p:spPr>
          <a:xfrm>
            <a:off x="234400" y="6133403"/>
            <a:ext cx="1176636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equence analysis of  target genes in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showing various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s. Cas9 target sequence is marked in red letters, PAM sequence is marked in bold letters, dash represents deletion, insertion of nucleotide is marked in blue letters and ‘*’ represents  nucleotides identical to those in the original wild-type sequence. The gel image represents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analysis of the T</a:t>
            </a:r>
            <a:r>
              <a:rPr lang="en-GB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transgenic plants showing the amplification of a 1839-bp SpCas9 gene and 615-bp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r>
              <a:rPr lang="en-GB" altLang="ko-KR" sz="14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.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neer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kb DNA ladder (Cat.#D-1041) and 100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ladder (Cat.#D-1030) were used as size marker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7575" y="4106017"/>
            <a:ext cx="4361349" cy="18867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745550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id="{C3055FE6-A6C9-5D24-6469-E148DCEEC356}"/>
              </a:ext>
            </a:extLst>
          </p:cNvPr>
          <p:cNvGrpSpPr/>
          <p:nvPr/>
        </p:nvGrpSpPr>
        <p:grpSpPr>
          <a:xfrm>
            <a:off x="729184" y="5610986"/>
            <a:ext cx="4007794" cy="1004378"/>
            <a:chOff x="2198133" y="5739011"/>
            <a:chExt cx="4007794" cy="1004378"/>
          </a:xfrm>
        </p:grpSpPr>
        <p:cxnSp>
          <p:nvCxnSpPr>
            <p:cNvPr id="3" name="직선 연결선 2">
              <a:extLst>
                <a:ext uri="{FF2B5EF4-FFF2-40B4-BE49-F238E27FC236}">
                  <a16:creationId xmlns:a16="http://schemas.microsoft.com/office/drawing/2014/main" id="{E4740423-6D6D-D872-434D-9710B0266816}"/>
                </a:ext>
              </a:extLst>
            </p:cNvPr>
            <p:cNvCxnSpPr/>
            <p:nvPr/>
          </p:nvCxnSpPr>
          <p:spPr>
            <a:xfrm>
              <a:off x="2296635" y="6008867"/>
              <a:ext cx="360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5155D3D6-0597-8DDC-6143-80B30D299C74}"/>
                </a:ext>
              </a:extLst>
            </p:cNvPr>
            <p:cNvSpPr/>
            <p:nvPr/>
          </p:nvSpPr>
          <p:spPr>
            <a:xfrm>
              <a:off x="2236881" y="5761243"/>
              <a:ext cx="425116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Line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7D80F1BB-A664-B3CF-FEE3-8597211ED8A7}"/>
                </a:ext>
              </a:extLst>
            </p:cNvPr>
            <p:cNvSpPr/>
            <p:nvPr/>
          </p:nvSpPr>
          <p:spPr>
            <a:xfrm>
              <a:off x="3726411" y="5751821"/>
              <a:ext cx="60465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GluC-1</a:t>
              </a:r>
              <a:endParaRPr lang="ko-KR" altLang="en-US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76B25837-C956-F604-8E3B-B227DD014EBD}"/>
                </a:ext>
              </a:extLst>
            </p:cNvPr>
            <p:cNvCxnSpPr/>
            <p:nvPr/>
          </p:nvCxnSpPr>
          <p:spPr>
            <a:xfrm>
              <a:off x="2903072" y="6008867"/>
              <a:ext cx="2160000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32B5E1CD-5263-4839-FB9E-B4C853E17B31}"/>
                </a:ext>
              </a:extLst>
            </p:cNvPr>
            <p:cNvCxnSpPr/>
            <p:nvPr/>
          </p:nvCxnSpPr>
          <p:spPr>
            <a:xfrm>
              <a:off x="5164673" y="6008867"/>
              <a:ext cx="252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id="{32B44B09-4B48-FF83-0A90-761A1A1BA30D}"/>
                </a:ext>
              </a:extLst>
            </p:cNvPr>
            <p:cNvCxnSpPr/>
            <p:nvPr/>
          </p:nvCxnSpPr>
          <p:spPr>
            <a:xfrm>
              <a:off x="5494732" y="6008867"/>
              <a:ext cx="540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93F96C8A-07AA-BCF9-9AA0-F87DCB507129}"/>
                </a:ext>
              </a:extLst>
            </p:cNvPr>
            <p:cNvSpPr/>
            <p:nvPr/>
          </p:nvSpPr>
          <p:spPr>
            <a:xfrm>
              <a:off x="5063072" y="5761243"/>
              <a:ext cx="46839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Type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D319163E-038F-B27F-3CD7-7E53D5797B71}"/>
                </a:ext>
              </a:extLst>
            </p:cNvPr>
            <p:cNvSpPr/>
            <p:nvPr/>
          </p:nvSpPr>
          <p:spPr>
            <a:xfrm>
              <a:off x="5418532" y="5761243"/>
              <a:ext cx="78739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Frequency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F71FB02-28D7-1885-27A3-932941AD6CC9}"/>
                </a:ext>
              </a:extLst>
            </p:cNvPr>
            <p:cNvSpPr txBox="1"/>
            <p:nvPr/>
          </p:nvSpPr>
          <p:spPr>
            <a:xfrm>
              <a:off x="5091926" y="6195652"/>
              <a:ext cx="385042" cy="525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e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8E684F5-C533-4804-6950-5BC6BA44350C}"/>
                </a:ext>
              </a:extLst>
            </p:cNvPr>
            <p:cNvSpPr txBox="1"/>
            <p:nvPr/>
          </p:nvSpPr>
          <p:spPr>
            <a:xfrm>
              <a:off x="5424566" y="6189391"/>
              <a:ext cx="545342" cy="525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en-US" altLang="ko-K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99.9%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1823911-B383-D6A9-4A43-C739AABDA748}"/>
                </a:ext>
              </a:extLst>
            </p:cNvPr>
            <p:cNvSpPr txBox="1"/>
            <p:nvPr/>
          </p:nvSpPr>
          <p:spPr>
            <a:xfrm>
              <a:off x="2219726" y="6195652"/>
              <a:ext cx="552000" cy="5254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lmi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c-2 -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86CBF5C-E175-337A-6B88-943E4BC5FF02}"/>
                </a:ext>
              </a:extLst>
            </p:cNvPr>
            <p:cNvSpPr txBox="1"/>
            <p:nvPr/>
          </p:nvSpPr>
          <p:spPr>
            <a:xfrm>
              <a:off x="4613689" y="6030518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/>
                  <a:cs typeface="Arial" panose="020B0604020202020204"/>
                </a:rPr>
                <a:t>PAM</a:t>
              </a:r>
              <a:endParaRPr lang="ko-KR" altLang="en-US" sz="1000" dirty="0"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EB5413B-D3F9-AD00-685F-EC6FE14A1C98}"/>
                </a:ext>
              </a:extLst>
            </p:cNvPr>
            <p:cNvSpPr txBox="1"/>
            <p:nvPr/>
          </p:nvSpPr>
          <p:spPr>
            <a:xfrm>
              <a:off x="3443658" y="6030518"/>
              <a:ext cx="12458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/>
                  <a:cs typeface="Arial" panose="020B0604020202020204"/>
                </a:rPr>
                <a:t>Target sequence 3</a:t>
              </a:r>
              <a:endParaRPr lang="ko-KR" altLang="en-US" sz="1000" dirty="0"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A2B3A19-1C39-929D-6812-CC3466828120}"/>
                </a:ext>
              </a:extLst>
            </p:cNvPr>
            <p:cNvSpPr txBox="1"/>
            <p:nvPr/>
          </p:nvSpPr>
          <p:spPr>
            <a:xfrm>
              <a:off x="2763228" y="6189391"/>
              <a:ext cx="2455956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>
                <a:lnSpc>
                  <a:spcPct val="150000"/>
                </a:lnSpc>
              </a:pPr>
              <a:r>
                <a:rPr lang="en-US" altLang="ko-KR" sz="1000" b="0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CCATTTTCA</a:t>
              </a:r>
              <a:r>
                <a:rPr lang="en-US" altLang="ko-KR" sz="1000" b="1" i="0" dirty="0">
                  <a:solidFill>
                    <a:srgbClr val="FF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ACTCTAATGATGGCACCTCT</a:t>
              </a:r>
              <a:r>
                <a:rPr lang="en-US" altLang="ko-KR" sz="1000" b="1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TGG</a:t>
              </a:r>
              <a:r>
                <a:rPr lang="en-US" altLang="ko-KR" sz="1000" b="0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GTC</a:t>
              </a:r>
            </a:p>
            <a:p>
              <a:pPr algn="l" fontAlgn="ctr">
                <a:lnSpc>
                  <a:spcPct val="150000"/>
                </a:lnSpc>
              </a:pPr>
              <a:r>
                <a:rPr lang="en-US" altLang="ko-KR" sz="100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**********************</a:t>
              </a:r>
              <a:r>
                <a:rPr lang="en-US" altLang="ko-KR" sz="1000" b="1" dirty="0">
                  <a:solidFill>
                    <a:srgbClr val="00B0F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----------</a:t>
              </a:r>
              <a:r>
                <a:rPr lang="en-US" altLang="ko-KR" sz="100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***</a:t>
              </a:r>
              <a:endPara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endParaRP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1CD96A20-3F4C-B9E1-F8D3-2853BEB668FD}"/>
                </a:ext>
              </a:extLst>
            </p:cNvPr>
            <p:cNvSpPr/>
            <p:nvPr/>
          </p:nvSpPr>
          <p:spPr>
            <a:xfrm>
              <a:off x="2198133" y="5739011"/>
              <a:ext cx="4006467" cy="10043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8" name="Rectangle 1">
            <a:extLst>
              <a:ext uri="{FF2B5EF4-FFF2-40B4-BE49-F238E27FC236}">
                <a16:creationId xmlns:a16="http://schemas.microsoft.com/office/drawing/2014/main" id="{C441D145-4791-37E3-BE8D-55A1C7BA5A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0821" y="3104636"/>
            <a:ext cx="2303868" cy="13849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G</a:t>
            </a:r>
            <a:endParaRPr lang="ko-KR" altLang="en-US" sz="1000" dirty="0">
              <a:latin typeface="SimSun-ExtB" panose="02010609060101010101" pitchFamily="49" charset="-122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GB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A6ABB499-7F04-A129-312C-E810A4E6F357}"/>
              </a:ext>
            </a:extLst>
          </p:cNvPr>
          <p:cNvCxnSpPr/>
          <p:nvPr/>
        </p:nvCxnSpPr>
        <p:spPr>
          <a:xfrm>
            <a:off x="753163" y="2865174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1C6609E5-412C-7EF4-17A9-EB6F86F24A8A}"/>
              </a:ext>
            </a:extLst>
          </p:cNvPr>
          <p:cNvSpPr/>
          <p:nvPr/>
        </p:nvSpPr>
        <p:spPr>
          <a:xfrm>
            <a:off x="753163" y="2617550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B69EA769-832A-C1B9-558A-FB5AC5E3658B}"/>
              </a:ext>
            </a:extLst>
          </p:cNvPr>
          <p:cNvSpPr/>
          <p:nvPr/>
        </p:nvSpPr>
        <p:spPr>
          <a:xfrm>
            <a:off x="2137093" y="2609186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-1a/b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E607D357-A68F-CCC9-979C-37A6A8B1F264}"/>
              </a:ext>
            </a:extLst>
          </p:cNvPr>
          <p:cNvCxnSpPr/>
          <p:nvPr/>
        </p:nvCxnSpPr>
        <p:spPr>
          <a:xfrm>
            <a:off x="1189565" y="2865174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DD829BC1-83FE-C13E-BFF5-BBC7C7A7B3C7}"/>
              </a:ext>
            </a:extLst>
          </p:cNvPr>
          <p:cNvCxnSpPr/>
          <p:nvPr/>
        </p:nvCxnSpPr>
        <p:spPr>
          <a:xfrm>
            <a:off x="3536929" y="2865174"/>
            <a:ext cx="252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B6631881-0E7D-F10B-7464-65189955A449}"/>
              </a:ext>
            </a:extLst>
          </p:cNvPr>
          <p:cNvCxnSpPr/>
          <p:nvPr/>
        </p:nvCxnSpPr>
        <p:spPr>
          <a:xfrm>
            <a:off x="3904760" y="2865174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01557787-749D-6F3E-3079-3320DC9374B3}"/>
              </a:ext>
            </a:extLst>
          </p:cNvPr>
          <p:cNvSpPr/>
          <p:nvPr/>
        </p:nvSpPr>
        <p:spPr>
          <a:xfrm>
            <a:off x="3467793" y="2617550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5EDD0D78-D24E-0BDC-5F8C-170E2CB67E79}"/>
              </a:ext>
            </a:extLst>
          </p:cNvPr>
          <p:cNvSpPr/>
          <p:nvPr/>
        </p:nvSpPr>
        <p:spPr>
          <a:xfrm>
            <a:off x="3823741" y="2617550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D852EE-5DFC-7B1D-F1C2-A5BB63D40B9D}"/>
              </a:ext>
            </a:extLst>
          </p:cNvPr>
          <p:cNvSpPr txBox="1"/>
          <p:nvPr/>
        </p:nvSpPr>
        <p:spPr>
          <a:xfrm>
            <a:off x="3509471" y="3317538"/>
            <a:ext cx="385042" cy="12464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CAD3223-3C88-91C0-AF0D-C67D5C95B308}"/>
              </a:ext>
            </a:extLst>
          </p:cNvPr>
          <p:cNvSpPr txBox="1"/>
          <p:nvPr/>
        </p:nvSpPr>
        <p:spPr>
          <a:xfrm>
            <a:off x="3824212" y="3081386"/>
            <a:ext cx="62054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7.02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7.12%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6.92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7.01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84F093A-3F3D-95B8-2ED0-C21193B48E3D}"/>
              </a:ext>
            </a:extLst>
          </p:cNvPr>
          <p:cNvSpPr txBox="1"/>
          <p:nvPr/>
        </p:nvSpPr>
        <p:spPr>
          <a:xfrm>
            <a:off x="735180" y="3085106"/>
            <a:ext cx="55335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b-5-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b-3-</a:t>
            </a: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b-3-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b-1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F2F7218-32CF-4DEA-7C0F-187B29DB5EA5}"/>
              </a:ext>
            </a:extLst>
          </p:cNvPr>
          <p:cNvSpPr txBox="1"/>
          <p:nvPr/>
        </p:nvSpPr>
        <p:spPr>
          <a:xfrm>
            <a:off x="2976417" y="2955537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849DB45-D6F0-1275-1E53-CF2A3492B3F0}"/>
              </a:ext>
            </a:extLst>
          </p:cNvPr>
          <p:cNvSpPr txBox="1"/>
          <p:nvPr/>
        </p:nvSpPr>
        <p:spPr>
          <a:xfrm>
            <a:off x="1806386" y="2955537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2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32" name="Rectangle 1">
            <a:extLst>
              <a:ext uri="{FF2B5EF4-FFF2-40B4-BE49-F238E27FC236}">
                <a16:creationId xmlns:a16="http://schemas.microsoft.com/office/drawing/2014/main" id="{DF5AAB9B-EA8A-8637-E183-FB157C18CE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8612" y="3125902"/>
            <a:ext cx="2303868" cy="138499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A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</a:t>
            </a:r>
            <a:r>
              <a:rPr kumimoji="0" lang="en-GB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T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endParaRPr lang="en-US" altLang="ko-KR" sz="1000" dirty="0">
              <a:solidFill>
                <a:srgbClr val="222222"/>
              </a:solidFill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-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endParaRPr lang="en-US" altLang="ko-KR" sz="1000" dirty="0">
              <a:solidFill>
                <a:srgbClr val="222222"/>
              </a:solidFill>
              <a:latin typeface="SimSun-ExtB" panose="02010609060101010101" pitchFamily="49" charset="-122"/>
            </a:endParaRPr>
          </a:p>
          <a:p>
            <a:pPr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</a:t>
            </a:r>
            <a:r>
              <a:rPr kumimoji="0" lang="en-US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T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</a:p>
          <a:p>
            <a:pPr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****************</a:t>
            </a:r>
            <a:r>
              <a:rPr lang="en-GB" altLang="ko-KR" sz="1000" b="1" dirty="0">
                <a:solidFill>
                  <a:srgbClr val="00B0F0"/>
                </a:solidFill>
                <a:latin typeface="SimSun-ExtB" panose="02010609060101010101" pitchFamily="49" charset="-122"/>
              </a:rPr>
              <a:t>T</a:t>
            </a:r>
            <a:r>
              <a:rPr lang="ko-KR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8AD51BDF-45B1-5039-2024-28294C1E1339}"/>
              </a:ext>
            </a:extLst>
          </p:cNvPr>
          <p:cNvSpPr/>
          <p:nvPr/>
        </p:nvSpPr>
        <p:spPr>
          <a:xfrm>
            <a:off x="5628220" y="2617550"/>
            <a:ext cx="60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-2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023011A3-B0D8-3071-DDCA-DDD11AD4EDBC}"/>
              </a:ext>
            </a:extLst>
          </p:cNvPr>
          <p:cNvCxnSpPr/>
          <p:nvPr/>
        </p:nvCxnSpPr>
        <p:spPr>
          <a:xfrm>
            <a:off x="4850546" y="2873538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74A454A7-DB57-72A0-363D-C6D34B8506B0}"/>
              </a:ext>
            </a:extLst>
          </p:cNvPr>
          <p:cNvCxnSpPr/>
          <p:nvPr/>
        </p:nvCxnSpPr>
        <p:spPr>
          <a:xfrm>
            <a:off x="7061391" y="2873538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75BF26B3-67BB-7605-22B2-5A5509CDB23B}"/>
              </a:ext>
            </a:extLst>
          </p:cNvPr>
          <p:cNvCxnSpPr/>
          <p:nvPr/>
        </p:nvCxnSpPr>
        <p:spPr>
          <a:xfrm>
            <a:off x="7519003" y="2873538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AE9A9C36-AE43-9B1A-DCEA-BD1F48F73A10}"/>
              </a:ext>
            </a:extLst>
          </p:cNvPr>
          <p:cNvSpPr/>
          <p:nvPr/>
        </p:nvSpPr>
        <p:spPr>
          <a:xfrm>
            <a:off x="7007192" y="2625914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DBDB72F5-5FBB-FEAA-71EF-519BD9FB59EE}"/>
              </a:ext>
            </a:extLst>
          </p:cNvPr>
          <p:cNvSpPr/>
          <p:nvPr/>
        </p:nvSpPr>
        <p:spPr>
          <a:xfrm>
            <a:off x="7395306" y="2625914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0B09CB5-3B1F-633C-31EA-A9BCDF50028D}"/>
              </a:ext>
            </a:extLst>
          </p:cNvPr>
          <p:cNvSpPr txBox="1"/>
          <p:nvPr/>
        </p:nvSpPr>
        <p:spPr>
          <a:xfrm>
            <a:off x="7150273" y="3087100"/>
            <a:ext cx="385042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E003228-5880-0DB1-2FF1-1017707A0FA7}"/>
              </a:ext>
            </a:extLst>
          </p:cNvPr>
          <p:cNvSpPr txBox="1"/>
          <p:nvPr/>
        </p:nvSpPr>
        <p:spPr>
          <a:xfrm>
            <a:off x="7498699" y="2860110"/>
            <a:ext cx="580608" cy="1708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7.2 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7.7 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2.2 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6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9%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674D09-2813-640B-753D-F30341C4BEC5}"/>
              </a:ext>
            </a:extLst>
          </p:cNvPr>
          <p:cNvSpPr txBox="1"/>
          <p:nvPr/>
        </p:nvSpPr>
        <p:spPr>
          <a:xfrm>
            <a:off x="6610551" y="2955537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3EB4FB-7656-3297-2A11-0C448552585B}"/>
              </a:ext>
            </a:extLst>
          </p:cNvPr>
          <p:cNvSpPr txBox="1"/>
          <p:nvPr/>
        </p:nvSpPr>
        <p:spPr>
          <a:xfrm>
            <a:off x="5332795" y="2955537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2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94ED8DFC-97BC-CCC1-90F8-9F6257F30FFC}"/>
              </a:ext>
            </a:extLst>
          </p:cNvPr>
          <p:cNvSpPr/>
          <p:nvPr/>
        </p:nvSpPr>
        <p:spPr>
          <a:xfrm>
            <a:off x="732239" y="2567847"/>
            <a:ext cx="7407175" cy="20892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Rectangle 1">
            <a:extLst>
              <a:ext uri="{FF2B5EF4-FFF2-40B4-BE49-F238E27FC236}">
                <a16:creationId xmlns:a16="http://schemas.microsoft.com/office/drawing/2014/main" id="{41E17780-A3C4-6108-65D0-A16EFE6EF7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2267" y="1009528"/>
            <a:ext cx="2422956" cy="1118063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----------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</a:t>
            </a:r>
            <a:r>
              <a:rPr kumimoji="0" lang="en-US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  <a:ea typeface="SimSun-ExtB" panose="02010609060101010101"/>
              </a:rPr>
              <a:t>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----------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</a:t>
            </a:r>
            <a:r>
              <a:rPr kumimoji="0" lang="en-US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  <a:ea typeface="SimSun-ExtB" panose="02010609060101010101"/>
              </a:rPr>
              <a:t>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5353FE5-0A26-4EE9-A6ED-2E45A932C4EF}"/>
              </a:ext>
            </a:extLst>
          </p:cNvPr>
          <p:cNvSpPr txBox="1"/>
          <p:nvPr/>
        </p:nvSpPr>
        <p:spPr>
          <a:xfrm>
            <a:off x="726580" y="947996"/>
            <a:ext cx="482824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a-1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a-2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a-5-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연결선 38">
            <a:extLst>
              <a:ext uri="{FF2B5EF4-FFF2-40B4-BE49-F238E27FC236}">
                <a16:creationId xmlns:a16="http://schemas.microsoft.com/office/drawing/2014/main" id="{0A10F93C-B649-E985-DA41-F74347042A5C}"/>
              </a:ext>
            </a:extLst>
          </p:cNvPr>
          <p:cNvCxnSpPr>
            <a:cxnSpLocks/>
          </p:cNvCxnSpPr>
          <p:nvPr/>
        </p:nvCxnSpPr>
        <p:spPr>
          <a:xfrm>
            <a:off x="760605" y="696260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직사각형 39">
            <a:extLst>
              <a:ext uri="{FF2B5EF4-FFF2-40B4-BE49-F238E27FC236}">
                <a16:creationId xmlns:a16="http://schemas.microsoft.com/office/drawing/2014/main" id="{D5DCE07F-4C07-CED4-7FCD-1A421DCC4988}"/>
              </a:ext>
            </a:extLst>
          </p:cNvPr>
          <p:cNvSpPr/>
          <p:nvPr/>
        </p:nvSpPr>
        <p:spPr>
          <a:xfrm>
            <a:off x="737888" y="448636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직사각형 40">
            <a:extLst>
              <a:ext uri="{FF2B5EF4-FFF2-40B4-BE49-F238E27FC236}">
                <a16:creationId xmlns:a16="http://schemas.microsoft.com/office/drawing/2014/main" id="{C97D7B55-2C56-6E2B-7644-D559A650C5E9}"/>
              </a:ext>
            </a:extLst>
          </p:cNvPr>
          <p:cNvSpPr/>
          <p:nvPr/>
        </p:nvSpPr>
        <p:spPr>
          <a:xfrm>
            <a:off x="2196382" y="469165"/>
            <a:ext cx="60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-1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49" name="직선 연결선 41">
            <a:extLst>
              <a:ext uri="{FF2B5EF4-FFF2-40B4-BE49-F238E27FC236}">
                <a16:creationId xmlns:a16="http://schemas.microsoft.com/office/drawing/2014/main" id="{0052094E-9D0C-0DF4-0E89-7079BB6AD2F8}"/>
              </a:ext>
            </a:extLst>
          </p:cNvPr>
          <p:cNvCxnSpPr>
            <a:cxnSpLocks/>
          </p:cNvCxnSpPr>
          <p:nvPr/>
        </p:nvCxnSpPr>
        <p:spPr>
          <a:xfrm>
            <a:off x="1183627" y="696260"/>
            <a:ext cx="234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1A0BB1DC-3BF4-E376-CFB3-40BE84639344}"/>
              </a:ext>
            </a:extLst>
          </p:cNvPr>
          <p:cNvSpPr txBox="1"/>
          <p:nvPr/>
        </p:nvSpPr>
        <p:spPr>
          <a:xfrm>
            <a:off x="3509471" y="946312"/>
            <a:ext cx="426716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C84DCE4-164F-DEB1-6F3E-CFD87CF57876}"/>
              </a:ext>
            </a:extLst>
          </p:cNvPr>
          <p:cNvSpPr txBox="1"/>
          <p:nvPr/>
        </p:nvSpPr>
        <p:spPr>
          <a:xfrm>
            <a:off x="3909501" y="1170843"/>
            <a:ext cx="61587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6 %</a:t>
            </a:r>
          </a:p>
          <a:p>
            <a:pPr algn="ct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7 %</a:t>
            </a:r>
          </a:p>
          <a:p>
            <a:pPr algn="ct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1.9 %</a:t>
            </a:r>
          </a:p>
          <a:p>
            <a:pPr algn="ct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7.6 %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직선 연결선 44">
            <a:extLst>
              <a:ext uri="{FF2B5EF4-FFF2-40B4-BE49-F238E27FC236}">
                <a16:creationId xmlns:a16="http://schemas.microsoft.com/office/drawing/2014/main" id="{7BD9F578-9722-609F-FC9F-6873DFCC40AF}"/>
              </a:ext>
            </a:extLst>
          </p:cNvPr>
          <p:cNvCxnSpPr>
            <a:cxnSpLocks/>
          </p:cNvCxnSpPr>
          <p:nvPr/>
        </p:nvCxnSpPr>
        <p:spPr>
          <a:xfrm>
            <a:off x="3574664" y="696260"/>
            <a:ext cx="27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직사각형 46">
            <a:extLst>
              <a:ext uri="{FF2B5EF4-FFF2-40B4-BE49-F238E27FC236}">
                <a16:creationId xmlns:a16="http://schemas.microsoft.com/office/drawing/2014/main" id="{0CD8A846-B43E-AA3C-1F16-97A85FE8CB41}"/>
              </a:ext>
            </a:extLst>
          </p:cNvPr>
          <p:cNvSpPr/>
          <p:nvPr/>
        </p:nvSpPr>
        <p:spPr>
          <a:xfrm>
            <a:off x="3472962" y="448636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직사각형 47">
            <a:extLst>
              <a:ext uri="{FF2B5EF4-FFF2-40B4-BE49-F238E27FC236}">
                <a16:creationId xmlns:a16="http://schemas.microsoft.com/office/drawing/2014/main" id="{C00165F2-A17F-D11B-0B18-D6DA445CD296}"/>
              </a:ext>
            </a:extLst>
          </p:cNvPr>
          <p:cNvSpPr/>
          <p:nvPr/>
        </p:nvSpPr>
        <p:spPr>
          <a:xfrm>
            <a:off x="3823741" y="448636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5" name="Rectangle 1">
            <a:extLst>
              <a:ext uri="{FF2B5EF4-FFF2-40B4-BE49-F238E27FC236}">
                <a16:creationId xmlns:a16="http://schemas.microsoft.com/office/drawing/2014/main" id="{C5751A9D-8FCF-785A-2040-68F1F011F3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96298" y="1009528"/>
            <a:ext cx="2268497" cy="88723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</a:t>
            </a:r>
            <a:r>
              <a:rPr kumimoji="0" lang="en-US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</p:txBody>
      </p:sp>
      <p:sp>
        <p:nvSpPr>
          <p:cNvPr id="56" name="직사각형 55">
            <a:extLst>
              <a:ext uri="{FF2B5EF4-FFF2-40B4-BE49-F238E27FC236}">
                <a16:creationId xmlns:a16="http://schemas.microsoft.com/office/drawing/2014/main" id="{C94B131F-6C9A-FF32-4517-A4D0BDE9F75B}"/>
              </a:ext>
            </a:extLst>
          </p:cNvPr>
          <p:cNvSpPr/>
          <p:nvPr/>
        </p:nvSpPr>
        <p:spPr>
          <a:xfrm>
            <a:off x="5628220" y="440272"/>
            <a:ext cx="60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-2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74961F5C-ED24-5607-2DB0-29E2264F27F9}"/>
              </a:ext>
            </a:extLst>
          </p:cNvPr>
          <p:cNvCxnSpPr>
            <a:cxnSpLocks/>
          </p:cNvCxnSpPr>
          <p:nvPr/>
        </p:nvCxnSpPr>
        <p:spPr>
          <a:xfrm>
            <a:off x="4850546" y="696260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45107E74-7E7D-A684-048F-B464FF8BEE65}"/>
              </a:ext>
            </a:extLst>
          </p:cNvPr>
          <p:cNvSpPr txBox="1"/>
          <p:nvPr/>
        </p:nvSpPr>
        <p:spPr>
          <a:xfrm>
            <a:off x="7132640" y="976051"/>
            <a:ext cx="420308" cy="9871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5808464-D4C2-B499-26A8-26B976664E8D}"/>
              </a:ext>
            </a:extLst>
          </p:cNvPr>
          <p:cNvSpPr txBox="1"/>
          <p:nvPr/>
        </p:nvSpPr>
        <p:spPr>
          <a:xfrm>
            <a:off x="7515376" y="1196173"/>
            <a:ext cx="54725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6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%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5%</a:t>
            </a: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BAD8016B-745D-85E9-CAB2-4609B0AD2786}"/>
              </a:ext>
            </a:extLst>
          </p:cNvPr>
          <p:cNvCxnSpPr>
            <a:cxnSpLocks/>
          </p:cNvCxnSpPr>
          <p:nvPr/>
        </p:nvCxnSpPr>
        <p:spPr>
          <a:xfrm>
            <a:off x="7061391" y="696260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2D5A5DA1-80B2-E3D6-8C30-BBB579BD1383}"/>
              </a:ext>
            </a:extLst>
          </p:cNvPr>
          <p:cNvCxnSpPr>
            <a:cxnSpLocks/>
          </p:cNvCxnSpPr>
          <p:nvPr/>
        </p:nvCxnSpPr>
        <p:spPr>
          <a:xfrm>
            <a:off x="7519003" y="696260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57036749-28D4-DD19-AFA3-79674DCEF255}"/>
              </a:ext>
            </a:extLst>
          </p:cNvPr>
          <p:cNvSpPr/>
          <p:nvPr/>
        </p:nvSpPr>
        <p:spPr>
          <a:xfrm>
            <a:off x="7007192" y="448636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C47D6478-6382-7361-585E-8E1FC06E8989}"/>
              </a:ext>
            </a:extLst>
          </p:cNvPr>
          <p:cNvSpPr/>
          <p:nvPr/>
        </p:nvSpPr>
        <p:spPr>
          <a:xfrm>
            <a:off x="7395306" y="448636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4" name="직사각형 73">
            <a:extLst>
              <a:ext uri="{FF2B5EF4-FFF2-40B4-BE49-F238E27FC236}">
                <a16:creationId xmlns:a16="http://schemas.microsoft.com/office/drawing/2014/main" id="{744960EF-BB5F-C5C0-B5C3-F242BE1D37DD}"/>
              </a:ext>
            </a:extLst>
          </p:cNvPr>
          <p:cNvSpPr/>
          <p:nvPr/>
        </p:nvSpPr>
        <p:spPr>
          <a:xfrm>
            <a:off x="718563" y="315362"/>
            <a:ext cx="7391418" cy="20526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F664478-9D3D-EA97-7A40-3CD2A2388DCB}"/>
              </a:ext>
            </a:extLst>
          </p:cNvPr>
          <p:cNvSpPr txBox="1"/>
          <p:nvPr/>
        </p:nvSpPr>
        <p:spPr>
          <a:xfrm>
            <a:off x="3020849" y="77397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22CE206-F50C-8810-AAD8-DBCA05AA3B46}"/>
              </a:ext>
            </a:extLst>
          </p:cNvPr>
          <p:cNvSpPr txBox="1"/>
          <p:nvPr/>
        </p:nvSpPr>
        <p:spPr>
          <a:xfrm>
            <a:off x="1850818" y="773978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1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ADF1F86-3E2F-6F12-7CAD-82AE33270B18}"/>
              </a:ext>
            </a:extLst>
          </p:cNvPr>
          <p:cNvSpPr txBox="1"/>
          <p:nvPr/>
        </p:nvSpPr>
        <p:spPr>
          <a:xfrm>
            <a:off x="6492238" y="77397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E2E4157-3DDA-D353-58D7-40F4CA743994}"/>
              </a:ext>
            </a:extLst>
          </p:cNvPr>
          <p:cNvSpPr txBox="1"/>
          <p:nvPr/>
        </p:nvSpPr>
        <p:spPr>
          <a:xfrm>
            <a:off x="5307619" y="773978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1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cxnSp>
        <p:nvCxnSpPr>
          <p:cNvPr id="69" name="직선 연결선 60">
            <a:extLst>
              <a:ext uri="{FF2B5EF4-FFF2-40B4-BE49-F238E27FC236}">
                <a16:creationId xmlns:a16="http://schemas.microsoft.com/office/drawing/2014/main" id="{E5312DE4-E717-2FAF-B9DA-B2B1451D4459}"/>
              </a:ext>
            </a:extLst>
          </p:cNvPr>
          <p:cNvCxnSpPr>
            <a:cxnSpLocks/>
          </p:cNvCxnSpPr>
          <p:nvPr/>
        </p:nvCxnSpPr>
        <p:spPr>
          <a:xfrm>
            <a:off x="3904760" y="700216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직사각형 1"/>
          <p:cNvSpPr/>
          <p:nvPr/>
        </p:nvSpPr>
        <p:spPr>
          <a:xfrm>
            <a:off x="8697433" y="3539279"/>
            <a:ext cx="3136604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nalysis of  target genes in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showing various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s. Cas9 target sequence is marked in red letters, PAM sequence is marked in bold letters, dash represents deletion, insertion of nucleotide is marked in blue letters and ‘*’ represents  nucleotides identical to those in the original wild-type sequence. The gel image represents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analysis of the T</a:t>
            </a:r>
            <a:r>
              <a:rPr lang="en-GB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transgenic plants showing the amplification of a 1839-bp SpCas9 gene and 615-bp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r>
              <a:rPr lang="en-GB" altLang="ko-KR" sz="14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.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neer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0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ladder (Cat.#D-1030) was used as size marker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just"/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43"/>
          <a:stretch/>
        </p:blipFill>
        <p:spPr bwMode="auto">
          <a:xfrm>
            <a:off x="4851759" y="4661414"/>
            <a:ext cx="3330942" cy="1953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313929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>
            <a:extLst>
              <a:ext uri="{FF2B5EF4-FFF2-40B4-BE49-F238E27FC236}">
                <a16:creationId xmlns:a16="http://schemas.microsoft.com/office/drawing/2014/main" id="{C3055FE6-A6C9-5D24-6469-E148DCEEC356}"/>
              </a:ext>
            </a:extLst>
          </p:cNvPr>
          <p:cNvGrpSpPr/>
          <p:nvPr/>
        </p:nvGrpSpPr>
        <p:grpSpPr>
          <a:xfrm>
            <a:off x="1051895" y="4341670"/>
            <a:ext cx="4017686" cy="1010639"/>
            <a:chOff x="2188241" y="5739011"/>
            <a:chExt cx="4017686" cy="1010639"/>
          </a:xfrm>
        </p:grpSpPr>
        <p:cxnSp>
          <p:nvCxnSpPr>
            <p:cNvPr id="3" name="직선 연결선 2">
              <a:extLst>
                <a:ext uri="{FF2B5EF4-FFF2-40B4-BE49-F238E27FC236}">
                  <a16:creationId xmlns:a16="http://schemas.microsoft.com/office/drawing/2014/main" id="{E4740423-6D6D-D872-434D-9710B0266816}"/>
                </a:ext>
              </a:extLst>
            </p:cNvPr>
            <p:cNvCxnSpPr/>
            <p:nvPr/>
          </p:nvCxnSpPr>
          <p:spPr>
            <a:xfrm>
              <a:off x="2296635" y="6008867"/>
              <a:ext cx="360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5155D3D6-0597-8DDC-6143-80B30D299C74}"/>
                </a:ext>
              </a:extLst>
            </p:cNvPr>
            <p:cNvSpPr/>
            <p:nvPr/>
          </p:nvSpPr>
          <p:spPr>
            <a:xfrm>
              <a:off x="2236881" y="5761243"/>
              <a:ext cx="425116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Line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" name="직사각형 4">
              <a:extLst>
                <a:ext uri="{FF2B5EF4-FFF2-40B4-BE49-F238E27FC236}">
                  <a16:creationId xmlns:a16="http://schemas.microsoft.com/office/drawing/2014/main" id="{7D80F1BB-A664-B3CF-FEE3-8597211ED8A7}"/>
                </a:ext>
              </a:extLst>
            </p:cNvPr>
            <p:cNvSpPr/>
            <p:nvPr/>
          </p:nvSpPr>
          <p:spPr>
            <a:xfrm>
              <a:off x="3726411" y="5751821"/>
              <a:ext cx="56137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GluC1</a:t>
              </a:r>
              <a:endParaRPr lang="ko-KR" altLang="en-US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76B25837-C956-F604-8E3B-B227DD014EBD}"/>
                </a:ext>
              </a:extLst>
            </p:cNvPr>
            <p:cNvCxnSpPr/>
            <p:nvPr/>
          </p:nvCxnSpPr>
          <p:spPr>
            <a:xfrm>
              <a:off x="2903072" y="6008867"/>
              <a:ext cx="2160000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32B5E1CD-5263-4839-FB9E-B4C853E17B31}"/>
                </a:ext>
              </a:extLst>
            </p:cNvPr>
            <p:cNvCxnSpPr/>
            <p:nvPr/>
          </p:nvCxnSpPr>
          <p:spPr>
            <a:xfrm>
              <a:off x="5164673" y="6008867"/>
              <a:ext cx="252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id="{32B44B09-4B48-FF83-0A90-761A1A1BA30D}"/>
                </a:ext>
              </a:extLst>
            </p:cNvPr>
            <p:cNvCxnSpPr/>
            <p:nvPr/>
          </p:nvCxnSpPr>
          <p:spPr>
            <a:xfrm>
              <a:off x="5494732" y="6008867"/>
              <a:ext cx="540000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93F96C8A-07AA-BCF9-9AA0-F87DCB507129}"/>
                </a:ext>
              </a:extLst>
            </p:cNvPr>
            <p:cNvSpPr/>
            <p:nvPr/>
          </p:nvSpPr>
          <p:spPr>
            <a:xfrm>
              <a:off x="5063072" y="5761243"/>
              <a:ext cx="46839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Type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D319163E-038F-B27F-3CD7-7E53D5797B71}"/>
                </a:ext>
              </a:extLst>
            </p:cNvPr>
            <p:cNvSpPr/>
            <p:nvPr/>
          </p:nvSpPr>
          <p:spPr>
            <a:xfrm>
              <a:off x="5418532" y="5761243"/>
              <a:ext cx="78739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Frequency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F71FB02-28D7-1885-27A3-932941AD6CC9}"/>
                </a:ext>
              </a:extLst>
            </p:cNvPr>
            <p:cNvSpPr txBox="1"/>
            <p:nvPr/>
          </p:nvSpPr>
          <p:spPr>
            <a:xfrm>
              <a:off x="5091926" y="6195652"/>
              <a:ext cx="385042" cy="525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Del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8E684F5-C533-4804-6950-5BC6BA44350C}"/>
                </a:ext>
              </a:extLst>
            </p:cNvPr>
            <p:cNvSpPr txBox="1"/>
            <p:nvPr/>
          </p:nvSpPr>
          <p:spPr>
            <a:xfrm>
              <a:off x="5424566" y="6189391"/>
              <a:ext cx="545342" cy="5254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en-US" altLang="ko-K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99.9%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1823911-B383-D6A9-4A43-C739AABDA748}"/>
                </a:ext>
              </a:extLst>
            </p:cNvPr>
            <p:cNvSpPr txBox="1"/>
            <p:nvPr/>
          </p:nvSpPr>
          <p:spPr>
            <a:xfrm>
              <a:off x="2188241" y="6195652"/>
              <a:ext cx="583485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lmi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-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c-2 -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86CBF5C-E175-337A-6B88-943E4BC5FF02}"/>
                </a:ext>
              </a:extLst>
            </p:cNvPr>
            <p:cNvSpPr txBox="1"/>
            <p:nvPr/>
          </p:nvSpPr>
          <p:spPr>
            <a:xfrm>
              <a:off x="4613689" y="6030518"/>
              <a:ext cx="4619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/>
                  <a:cs typeface="Arial" panose="020B0604020202020204"/>
                </a:rPr>
                <a:t>PAM</a:t>
              </a:r>
              <a:endParaRPr lang="ko-KR" altLang="en-US" sz="1000" dirty="0"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EB5413B-D3F9-AD00-685F-EC6FE14A1C98}"/>
                </a:ext>
              </a:extLst>
            </p:cNvPr>
            <p:cNvSpPr txBox="1"/>
            <p:nvPr/>
          </p:nvSpPr>
          <p:spPr>
            <a:xfrm>
              <a:off x="3443658" y="6030518"/>
              <a:ext cx="12458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/>
                  <a:cs typeface="Arial" panose="020B0604020202020204"/>
                </a:rPr>
                <a:t>Target sequence 3</a:t>
              </a:r>
              <a:endParaRPr lang="ko-KR" altLang="en-US" sz="1000" dirty="0">
                <a:latin typeface="Arial" panose="020B0604020202020204"/>
                <a:cs typeface="Arial" panose="020B0604020202020204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A2B3A19-1C39-929D-6812-CC3466828120}"/>
                </a:ext>
              </a:extLst>
            </p:cNvPr>
            <p:cNvSpPr txBox="1"/>
            <p:nvPr/>
          </p:nvSpPr>
          <p:spPr>
            <a:xfrm>
              <a:off x="2763228" y="6189391"/>
              <a:ext cx="2455956" cy="5539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l" fontAlgn="ctr">
                <a:lnSpc>
                  <a:spcPct val="150000"/>
                </a:lnSpc>
              </a:pPr>
              <a:r>
                <a:rPr lang="en-US" altLang="ko-KR" sz="1000" b="0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CCATTTTCA</a:t>
              </a:r>
              <a:r>
                <a:rPr lang="en-US" altLang="ko-KR" sz="1000" b="1" i="0" dirty="0">
                  <a:solidFill>
                    <a:srgbClr val="FF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ACTCTAATGATGGCACCTCT</a:t>
              </a:r>
              <a:r>
                <a:rPr lang="en-US" altLang="ko-KR" sz="1000" b="1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TGG</a:t>
              </a:r>
              <a:r>
                <a:rPr lang="en-US" altLang="ko-KR" sz="1000" b="0" i="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GTC</a:t>
              </a:r>
            </a:p>
            <a:p>
              <a:pPr algn="l" fontAlgn="ctr">
                <a:lnSpc>
                  <a:spcPct val="150000"/>
                </a:lnSpc>
              </a:pPr>
              <a:r>
                <a:rPr lang="en-US" altLang="ko-KR" sz="100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**********************</a:t>
              </a:r>
              <a:r>
                <a:rPr lang="en-US" altLang="ko-KR" sz="1000" b="1" dirty="0">
                  <a:solidFill>
                    <a:srgbClr val="00B0F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----------</a:t>
              </a:r>
              <a:r>
                <a:rPr lang="en-US" altLang="ko-KR" sz="1000" dirty="0">
                  <a:solidFill>
                    <a:srgbClr val="000000"/>
                  </a:solidFill>
                  <a:latin typeface="SimSun-ExtB" panose="02010609060101010101" pitchFamily="49" charset="-122"/>
                  <a:ea typeface="SimSun-ExtB" panose="02010609060101010101" pitchFamily="49" charset="-122"/>
                </a:rPr>
                <a:t>***</a:t>
              </a:r>
              <a:endPara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endParaRP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1CD96A20-3F4C-B9E1-F8D3-2853BEB668FD}"/>
                </a:ext>
              </a:extLst>
            </p:cNvPr>
            <p:cNvSpPr/>
            <p:nvPr/>
          </p:nvSpPr>
          <p:spPr>
            <a:xfrm>
              <a:off x="2198133" y="5739011"/>
              <a:ext cx="4006467" cy="10043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8" name="Rectangle 1">
            <a:extLst>
              <a:ext uri="{FF2B5EF4-FFF2-40B4-BE49-F238E27FC236}">
                <a16:creationId xmlns:a16="http://schemas.microsoft.com/office/drawing/2014/main" id="{C441D145-4791-37E3-BE8D-55A1C7BA5A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2952" y="2748352"/>
            <a:ext cx="2303868" cy="46166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G</a:t>
            </a:r>
            <a:endParaRPr lang="ko-KR" altLang="en-US" sz="1000" dirty="0">
              <a:latin typeface="SimSun-ExtB" panose="02010609060101010101" pitchFamily="49" charset="-122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A6ABB499-7F04-A129-312C-E810A4E6F357}"/>
              </a:ext>
            </a:extLst>
          </p:cNvPr>
          <p:cNvCxnSpPr/>
          <p:nvPr/>
        </p:nvCxnSpPr>
        <p:spPr>
          <a:xfrm>
            <a:off x="1035294" y="2468557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1C6609E5-412C-7EF4-17A9-EB6F86F24A8A}"/>
              </a:ext>
            </a:extLst>
          </p:cNvPr>
          <p:cNvSpPr/>
          <p:nvPr/>
        </p:nvSpPr>
        <p:spPr>
          <a:xfrm>
            <a:off x="1035294" y="2220933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B69EA769-832A-C1B9-558A-FB5AC5E3658B}"/>
              </a:ext>
            </a:extLst>
          </p:cNvPr>
          <p:cNvSpPr/>
          <p:nvPr/>
        </p:nvSpPr>
        <p:spPr>
          <a:xfrm>
            <a:off x="2419224" y="2212569"/>
            <a:ext cx="74571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1a/b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E607D357-A68F-CCC9-979C-37A6A8B1F264}"/>
              </a:ext>
            </a:extLst>
          </p:cNvPr>
          <p:cNvCxnSpPr/>
          <p:nvPr/>
        </p:nvCxnSpPr>
        <p:spPr>
          <a:xfrm>
            <a:off x="1471696" y="2468557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DD829BC1-83FE-C13E-BFF5-BBC7C7A7B3C7}"/>
              </a:ext>
            </a:extLst>
          </p:cNvPr>
          <p:cNvCxnSpPr/>
          <p:nvPr/>
        </p:nvCxnSpPr>
        <p:spPr>
          <a:xfrm>
            <a:off x="3819060" y="2468557"/>
            <a:ext cx="252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B6631881-0E7D-F10B-7464-65189955A449}"/>
              </a:ext>
            </a:extLst>
          </p:cNvPr>
          <p:cNvCxnSpPr/>
          <p:nvPr/>
        </p:nvCxnSpPr>
        <p:spPr>
          <a:xfrm>
            <a:off x="4186891" y="2468557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01557787-749D-6F3E-3079-3320DC9374B3}"/>
              </a:ext>
            </a:extLst>
          </p:cNvPr>
          <p:cNvSpPr/>
          <p:nvPr/>
        </p:nvSpPr>
        <p:spPr>
          <a:xfrm>
            <a:off x="3749924" y="2220933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5EDD0D78-D24E-0BDC-5F8C-170E2CB67E79}"/>
              </a:ext>
            </a:extLst>
          </p:cNvPr>
          <p:cNvSpPr/>
          <p:nvPr/>
        </p:nvSpPr>
        <p:spPr>
          <a:xfrm>
            <a:off x="4105872" y="2220933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D852EE-5DFC-7B1D-F1C2-A5BB63D40B9D}"/>
              </a:ext>
            </a:extLst>
          </p:cNvPr>
          <p:cNvSpPr txBox="1"/>
          <p:nvPr/>
        </p:nvSpPr>
        <p:spPr>
          <a:xfrm>
            <a:off x="3791602" y="2697571"/>
            <a:ext cx="38504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GB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CAD3223-3C88-91C0-AF0D-C67D5C95B308}"/>
              </a:ext>
            </a:extLst>
          </p:cNvPr>
          <p:cNvSpPr txBox="1"/>
          <p:nvPr/>
        </p:nvSpPr>
        <p:spPr>
          <a:xfrm>
            <a:off x="4106343" y="2684769"/>
            <a:ext cx="62054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7.02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84F093A-3F3D-95B8-2ED0-C21193B48E3D}"/>
              </a:ext>
            </a:extLst>
          </p:cNvPr>
          <p:cNvSpPr txBox="1"/>
          <p:nvPr/>
        </p:nvSpPr>
        <p:spPr>
          <a:xfrm>
            <a:off x="1017311" y="2688489"/>
            <a:ext cx="5533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b-5-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F2F7218-32CF-4DEA-7C0F-187B29DB5EA5}"/>
              </a:ext>
            </a:extLst>
          </p:cNvPr>
          <p:cNvSpPr txBox="1"/>
          <p:nvPr/>
        </p:nvSpPr>
        <p:spPr>
          <a:xfrm>
            <a:off x="3258548" y="255892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849DB45-D6F0-1275-1E53-CF2A3492B3F0}"/>
              </a:ext>
            </a:extLst>
          </p:cNvPr>
          <p:cNvSpPr txBox="1"/>
          <p:nvPr/>
        </p:nvSpPr>
        <p:spPr>
          <a:xfrm>
            <a:off x="2088517" y="2558920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2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32" name="Rectangle 1">
            <a:extLst>
              <a:ext uri="{FF2B5EF4-FFF2-40B4-BE49-F238E27FC236}">
                <a16:creationId xmlns:a16="http://schemas.microsoft.com/office/drawing/2014/main" id="{DF5AAB9B-EA8A-8637-E183-FB157C18CE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0743" y="2780822"/>
            <a:ext cx="2303868" cy="46166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ATGCTCAT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TTTGGTCTATATGA</a:t>
            </a:r>
            <a:r>
              <a:rPr lang="en-US" altLang="ko-KR" sz="1000" dirty="0">
                <a:solidFill>
                  <a:srgbClr val="222222"/>
                </a:solidFill>
                <a:latin typeface="SimSun-ExtB" panose="02010609060101010101"/>
                <a:ea typeface="SimSun-ExtB" panose="02010609060101010101"/>
              </a:rPr>
              <a:t>…</a:t>
            </a:r>
            <a:r>
              <a:rPr lang="en-US" altLang="ko-KR" sz="1000" b="1" i="0" u="none" strike="noStrike" dirty="0">
                <a:solidFill>
                  <a:srgbClr val="FF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TTCA</a:t>
            </a:r>
            <a:r>
              <a:rPr lang="en-US" altLang="ko-KR" sz="1000" b="1" i="0" u="none" strike="noStrike" dirty="0"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AGG</a:t>
            </a:r>
            <a:r>
              <a:rPr lang="en-US" altLang="ko-KR" sz="1000" b="0" i="0" u="none" strike="noStrike" dirty="0">
                <a:solidFill>
                  <a:srgbClr val="000000"/>
                </a:solidFill>
                <a:effectLst/>
                <a:latin typeface="SimSun-ExtB" panose="02010609060101010101" pitchFamily="49" charset="-122"/>
                <a:ea typeface="SimSun-ExtB" panose="02010609060101010101" pitchFamily="49" charset="-122"/>
              </a:rPr>
              <a:t>GCA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 pitchFamily="49" charset="-122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****************</a:t>
            </a:r>
            <a:r>
              <a:rPr kumimoji="0" lang="en-GB" altLang="ko-KR" sz="1000" b="1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 pitchFamily="49" charset="-122"/>
              </a:rPr>
              <a:t>T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 pitchFamily="49" charset="-122"/>
              </a:rPr>
              <a:t>*********</a:t>
            </a:r>
            <a:r>
              <a:rPr lang="en-GB" altLang="ko-KR" sz="1000" dirty="0">
                <a:solidFill>
                  <a:srgbClr val="222222"/>
                </a:solidFill>
                <a:latin typeface="SimSun-ExtB" panose="02010609060101010101" pitchFamily="49" charset="-122"/>
              </a:rPr>
              <a:t>*</a:t>
            </a:r>
            <a:endParaRPr lang="en-US" altLang="ko-KR" sz="1000" dirty="0">
              <a:solidFill>
                <a:srgbClr val="222222"/>
              </a:solidFill>
              <a:latin typeface="SimSun-ExtB" panose="02010609060101010101" pitchFamily="49" charset="-122"/>
            </a:endParaRPr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8AD51BDF-45B1-5039-2024-28294C1E1339}"/>
              </a:ext>
            </a:extLst>
          </p:cNvPr>
          <p:cNvSpPr/>
          <p:nvPr/>
        </p:nvSpPr>
        <p:spPr>
          <a:xfrm>
            <a:off x="5910351" y="2220933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B2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023011A3-B0D8-3071-DDCA-DDD11AD4EDBC}"/>
              </a:ext>
            </a:extLst>
          </p:cNvPr>
          <p:cNvCxnSpPr/>
          <p:nvPr/>
        </p:nvCxnSpPr>
        <p:spPr>
          <a:xfrm>
            <a:off x="5132677" y="2476921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74A454A7-DB57-72A0-363D-C6D34B8506B0}"/>
              </a:ext>
            </a:extLst>
          </p:cNvPr>
          <p:cNvCxnSpPr/>
          <p:nvPr/>
        </p:nvCxnSpPr>
        <p:spPr>
          <a:xfrm>
            <a:off x="7343522" y="2476921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75BF26B3-67BB-7605-22B2-5A5509CDB23B}"/>
              </a:ext>
            </a:extLst>
          </p:cNvPr>
          <p:cNvCxnSpPr/>
          <p:nvPr/>
        </p:nvCxnSpPr>
        <p:spPr>
          <a:xfrm>
            <a:off x="7801134" y="2476921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AE9A9C36-AE43-9B1A-DCEA-BD1F48F73A10}"/>
              </a:ext>
            </a:extLst>
          </p:cNvPr>
          <p:cNvSpPr/>
          <p:nvPr/>
        </p:nvSpPr>
        <p:spPr>
          <a:xfrm>
            <a:off x="7289323" y="2229297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DBDB72F5-5FBB-FEAA-71EF-519BD9FB59EE}"/>
              </a:ext>
            </a:extLst>
          </p:cNvPr>
          <p:cNvSpPr/>
          <p:nvPr/>
        </p:nvSpPr>
        <p:spPr>
          <a:xfrm>
            <a:off x="7677437" y="2229297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0B09CB5-3B1F-633C-31EA-A9BCDF50028D}"/>
              </a:ext>
            </a:extLst>
          </p:cNvPr>
          <p:cNvSpPr txBox="1"/>
          <p:nvPr/>
        </p:nvSpPr>
        <p:spPr>
          <a:xfrm>
            <a:off x="7432404" y="2690483"/>
            <a:ext cx="38504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In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E003228-5880-0DB1-2FF1-1017707A0FA7}"/>
              </a:ext>
            </a:extLst>
          </p:cNvPr>
          <p:cNvSpPr txBox="1"/>
          <p:nvPr/>
        </p:nvSpPr>
        <p:spPr>
          <a:xfrm>
            <a:off x="7789710" y="2458790"/>
            <a:ext cx="545342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9%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674D09-2813-640B-753D-F30341C4BEC5}"/>
              </a:ext>
            </a:extLst>
          </p:cNvPr>
          <p:cNvSpPr txBox="1"/>
          <p:nvPr/>
        </p:nvSpPr>
        <p:spPr>
          <a:xfrm>
            <a:off x="6892682" y="255892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3EB4FB-7656-3297-2A11-0C448552585B}"/>
              </a:ext>
            </a:extLst>
          </p:cNvPr>
          <p:cNvSpPr txBox="1"/>
          <p:nvPr/>
        </p:nvSpPr>
        <p:spPr>
          <a:xfrm>
            <a:off x="5614926" y="2558920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2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94ED8DFC-97BC-CCC1-90F8-9F6257F30FFC}"/>
              </a:ext>
            </a:extLst>
          </p:cNvPr>
          <p:cNvSpPr/>
          <p:nvPr/>
        </p:nvSpPr>
        <p:spPr>
          <a:xfrm>
            <a:off x="1014370" y="2171230"/>
            <a:ext cx="7407175" cy="11488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Rectangle 1">
            <a:extLst>
              <a:ext uri="{FF2B5EF4-FFF2-40B4-BE49-F238E27FC236}">
                <a16:creationId xmlns:a16="http://schemas.microsoft.com/office/drawing/2014/main" id="{41E17780-A3C4-6108-65D0-A16EFE6EF7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183" y="1046497"/>
            <a:ext cx="2422956" cy="46166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lv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00B0F0"/>
                </a:solidFill>
                <a:effectLst/>
                <a:latin typeface="SimSun-ExtB" panose="02010609060101010101"/>
              </a:rPr>
              <a:t>-------------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5353FE5-0A26-4EE9-A6ED-2E45A932C4EF}"/>
              </a:ext>
            </a:extLst>
          </p:cNvPr>
          <p:cNvSpPr txBox="1"/>
          <p:nvPr/>
        </p:nvSpPr>
        <p:spPr>
          <a:xfrm>
            <a:off x="935323" y="987518"/>
            <a:ext cx="55335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lmi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a-1-2</a:t>
            </a:r>
          </a:p>
        </p:txBody>
      </p:sp>
      <p:cxnSp>
        <p:nvCxnSpPr>
          <p:cNvPr id="46" name="직선 연결선 38">
            <a:extLst>
              <a:ext uri="{FF2B5EF4-FFF2-40B4-BE49-F238E27FC236}">
                <a16:creationId xmlns:a16="http://schemas.microsoft.com/office/drawing/2014/main" id="{0A10F93C-B649-E985-DA41-F74347042A5C}"/>
              </a:ext>
            </a:extLst>
          </p:cNvPr>
          <p:cNvCxnSpPr>
            <a:cxnSpLocks/>
          </p:cNvCxnSpPr>
          <p:nvPr/>
        </p:nvCxnSpPr>
        <p:spPr>
          <a:xfrm>
            <a:off x="1088521" y="735782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직사각형 39">
            <a:extLst>
              <a:ext uri="{FF2B5EF4-FFF2-40B4-BE49-F238E27FC236}">
                <a16:creationId xmlns:a16="http://schemas.microsoft.com/office/drawing/2014/main" id="{D5DCE07F-4C07-CED4-7FCD-1A421DCC4988}"/>
              </a:ext>
            </a:extLst>
          </p:cNvPr>
          <p:cNvSpPr/>
          <p:nvPr/>
        </p:nvSpPr>
        <p:spPr>
          <a:xfrm>
            <a:off x="1065804" y="488158"/>
            <a:ext cx="4251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Lin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직사각형 40">
            <a:extLst>
              <a:ext uri="{FF2B5EF4-FFF2-40B4-BE49-F238E27FC236}">
                <a16:creationId xmlns:a16="http://schemas.microsoft.com/office/drawing/2014/main" id="{C97D7B55-2C56-6E2B-7644-D559A650C5E9}"/>
              </a:ext>
            </a:extLst>
          </p:cNvPr>
          <p:cNvSpPr/>
          <p:nvPr/>
        </p:nvSpPr>
        <p:spPr>
          <a:xfrm>
            <a:off x="2524298" y="508687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1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49" name="직선 연결선 41">
            <a:extLst>
              <a:ext uri="{FF2B5EF4-FFF2-40B4-BE49-F238E27FC236}">
                <a16:creationId xmlns:a16="http://schemas.microsoft.com/office/drawing/2014/main" id="{0052094E-9D0C-0DF4-0E89-7079BB6AD2F8}"/>
              </a:ext>
            </a:extLst>
          </p:cNvPr>
          <p:cNvCxnSpPr>
            <a:cxnSpLocks/>
          </p:cNvCxnSpPr>
          <p:nvPr/>
        </p:nvCxnSpPr>
        <p:spPr>
          <a:xfrm>
            <a:off x="1511543" y="735782"/>
            <a:ext cx="234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1A0BB1DC-3BF4-E376-CFB3-40BE84639344}"/>
              </a:ext>
            </a:extLst>
          </p:cNvPr>
          <p:cNvSpPr txBox="1"/>
          <p:nvPr/>
        </p:nvSpPr>
        <p:spPr>
          <a:xfrm>
            <a:off x="3837387" y="985834"/>
            <a:ext cx="42671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el 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C84DCE4-164F-DEB1-6F3E-CFD87CF57876}"/>
              </a:ext>
            </a:extLst>
          </p:cNvPr>
          <p:cNvSpPr txBox="1"/>
          <p:nvPr/>
        </p:nvSpPr>
        <p:spPr>
          <a:xfrm>
            <a:off x="4237417" y="1210365"/>
            <a:ext cx="61587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6 %</a:t>
            </a:r>
          </a:p>
        </p:txBody>
      </p:sp>
      <p:cxnSp>
        <p:nvCxnSpPr>
          <p:cNvPr id="52" name="직선 연결선 44">
            <a:extLst>
              <a:ext uri="{FF2B5EF4-FFF2-40B4-BE49-F238E27FC236}">
                <a16:creationId xmlns:a16="http://schemas.microsoft.com/office/drawing/2014/main" id="{7BD9F578-9722-609F-FC9F-6873DFCC40AF}"/>
              </a:ext>
            </a:extLst>
          </p:cNvPr>
          <p:cNvCxnSpPr>
            <a:cxnSpLocks/>
          </p:cNvCxnSpPr>
          <p:nvPr/>
        </p:nvCxnSpPr>
        <p:spPr>
          <a:xfrm>
            <a:off x="3902580" y="735782"/>
            <a:ext cx="27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직사각형 46">
            <a:extLst>
              <a:ext uri="{FF2B5EF4-FFF2-40B4-BE49-F238E27FC236}">
                <a16:creationId xmlns:a16="http://schemas.microsoft.com/office/drawing/2014/main" id="{0CD8A846-B43E-AA3C-1F16-97A85FE8CB41}"/>
              </a:ext>
            </a:extLst>
          </p:cNvPr>
          <p:cNvSpPr/>
          <p:nvPr/>
        </p:nvSpPr>
        <p:spPr>
          <a:xfrm>
            <a:off x="3800878" y="488158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직사각형 47">
            <a:extLst>
              <a:ext uri="{FF2B5EF4-FFF2-40B4-BE49-F238E27FC236}">
                <a16:creationId xmlns:a16="http://schemas.microsoft.com/office/drawing/2014/main" id="{C00165F2-A17F-D11B-0B18-D6DA445CD296}"/>
              </a:ext>
            </a:extLst>
          </p:cNvPr>
          <p:cNvSpPr/>
          <p:nvPr/>
        </p:nvSpPr>
        <p:spPr>
          <a:xfrm>
            <a:off x="4151657" y="488158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5" name="Rectangle 1">
            <a:extLst>
              <a:ext uri="{FF2B5EF4-FFF2-40B4-BE49-F238E27FC236}">
                <a16:creationId xmlns:a16="http://schemas.microsoft.com/office/drawing/2014/main" id="{C5751A9D-8FCF-785A-2040-68F1F011F3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24214" y="1067273"/>
            <a:ext cx="2268497" cy="46166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ACGCTCAC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SimSun-ExtB" panose="02010609060101010101"/>
              </a:rPr>
              <a:t>AGCGTCGTGTATATTACTCA</a:t>
            </a:r>
            <a:r>
              <a:rPr kumimoji="0" lang="ko-KR" altLang="ko-KR" sz="1000" b="1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AGG</a:t>
            </a: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CCG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  <a:ea typeface="SimSun-ExtB" panose="02010609060101010101"/>
            </a:endParaRPr>
          </a:p>
          <a:p>
            <a:pPr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ko-KR" altLang="ko-KR" sz="10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SimSun-ExtB" panose="02010609060101010101"/>
              </a:rPr>
              <a:t>***********************************</a:t>
            </a:r>
            <a:endParaRPr kumimoji="0" lang="en-US" altLang="ko-KR" sz="1000" b="0" i="0" u="none" strike="noStrike" cap="none" normalizeH="0" baseline="0" dirty="0">
              <a:ln>
                <a:noFill/>
              </a:ln>
              <a:solidFill>
                <a:srgbClr val="222222"/>
              </a:solidFill>
              <a:effectLst/>
              <a:latin typeface="SimSun-ExtB" panose="02010609060101010101"/>
            </a:endParaRPr>
          </a:p>
        </p:txBody>
      </p:sp>
      <p:sp>
        <p:nvSpPr>
          <p:cNvPr id="56" name="직사각형 55">
            <a:extLst>
              <a:ext uri="{FF2B5EF4-FFF2-40B4-BE49-F238E27FC236}">
                <a16:creationId xmlns:a16="http://schemas.microsoft.com/office/drawing/2014/main" id="{C94B131F-6C9A-FF32-4517-A4D0BDE9F75B}"/>
              </a:ext>
            </a:extLst>
          </p:cNvPr>
          <p:cNvSpPr/>
          <p:nvPr/>
        </p:nvSpPr>
        <p:spPr>
          <a:xfrm>
            <a:off x="5956136" y="479794"/>
            <a:ext cx="5613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luA2</a:t>
            </a:r>
            <a:endParaRPr lang="ko-KR" altLang="en-US" sz="1000" b="1" i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74961F5C-ED24-5607-2DB0-29E2264F27F9}"/>
              </a:ext>
            </a:extLst>
          </p:cNvPr>
          <p:cNvCxnSpPr>
            <a:cxnSpLocks/>
          </p:cNvCxnSpPr>
          <p:nvPr/>
        </p:nvCxnSpPr>
        <p:spPr>
          <a:xfrm>
            <a:off x="5178462" y="735782"/>
            <a:ext cx="2160000" cy="0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45107E74-7E7D-A684-048F-B464FF8BEE65}"/>
              </a:ext>
            </a:extLst>
          </p:cNvPr>
          <p:cNvSpPr txBox="1"/>
          <p:nvPr/>
        </p:nvSpPr>
        <p:spPr>
          <a:xfrm>
            <a:off x="7460556" y="1015573"/>
            <a:ext cx="42030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5808464-D4C2-B499-26A8-26B976664E8D}"/>
              </a:ext>
            </a:extLst>
          </p:cNvPr>
          <p:cNvSpPr txBox="1"/>
          <p:nvPr/>
        </p:nvSpPr>
        <p:spPr>
          <a:xfrm>
            <a:off x="7843292" y="1235695"/>
            <a:ext cx="547255" cy="294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9.6%</a:t>
            </a:r>
          </a:p>
        </p:txBody>
      </p: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BAD8016B-745D-85E9-CAB2-4609B0AD2786}"/>
              </a:ext>
            </a:extLst>
          </p:cNvPr>
          <p:cNvCxnSpPr>
            <a:cxnSpLocks/>
          </p:cNvCxnSpPr>
          <p:nvPr/>
        </p:nvCxnSpPr>
        <p:spPr>
          <a:xfrm>
            <a:off x="7389307" y="735782"/>
            <a:ext cx="36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2D5A5DA1-80B2-E3D6-8C30-BBB579BD1383}"/>
              </a:ext>
            </a:extLst>
          </p:cNvPr>
          <p:cNvCxnSpPr>
            <a:cxnSpLocks/>
          </p:cNvCxnSpPr>
          <p:nvPr/>
        </p:nvCxnSpPr>
        <p:spPr>
          <a:xfrm>
            <a:off x="7846919" y="735782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57036749-28D4-DD19-AFA3-79674DCEF255}"/>
              </a:ext>
            </a:extLst>
          </p:cNvPr>
          <p:cNvSpPr/>
          <p:nvPr/>
        </p:nvSpPr>
        <p:spPr>
          <a:xfrm>
            <a:off x="7335108" y="488158"/>
            <a:ext cx="4683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ype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C47D6478-6382-7361-585E-8E1FC06E8989}"/>
              </a:ext>
            </a:extLst>
          </p:cNvPr>
          <p:cNvSpPr/>
          <p:nvPr/>
        </p:nvSpPr>
        <p:spPr>
          <a:xfrm>
            <a:off x="7723222" y="488158"/>
            <a:ext cx="78739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requency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4" name="직사각형 73">
            <a:extLst>
              <a:ext uri="{FF2B5EF4-FFF2-40B4-BE49-F238E27FC236}">
                <a16:creationId xmlns:a16="http://schemas.microsoft.com/office/drawing/2014/main" id="{744960EF-BB5F-C5C0-B5C3-F242BE1D37DD}"/>
              </a:ext>
            </a:extLst>
          </p:cNvPr>
          <p:cNvSpPr/>
          <p:nvPr/>
        </p:nvSpPr>
        <p:spPr>
          <a:xfrm>
            <a:off x="1030127" y="346988"/>
            <a:ext cx="7391418" cy="14294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F664478-9D3D-EA97-7A40-3CD2A2388DCB}"/>
              </a:ext>
            </a:extLst>
          </p:cNvPr>
          <p:cNvSpPr txBox="1"/>
          <p:nvPr/>
        </p:nvSpPr>
        <p:spPr>
          <a:xfrm>
            <a:off x="3348765" y="81350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22CE206-F50C-8810-AAD8-DBCA05AA3B46}"/>
              </a:ext>
            </a:extLst>
          </p:cNvPr>
          <p:cNvSpPr txBox="1"/>
          <p:nvPr/>
        </p:nvSpPr>
        <p:spPr>
          <a:xfrm>
            <a:off x="2178734" y="813500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1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ADF1F86-3E2F-6F12-7CAD-82AE33270B18}"/>
              </a:ext>
            </a:extLst>
          </p:cNvPr>
          <p:cNvSpPr txBox="1"/>
          <p:nvPr/>
        </p:nvSpPr>
        <p:spPr>
          <a:xfrm>
            <a:off x="6820154" y="813500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PAM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E2E4157-3DDA-D353-58D7-40F4CA743994}"/>
              </a:ext>
            </a:extLst>
          </p:cNvPr>
          <p:cNvSpPr txBox="1"/>
          <p:nvPr/>
        </p:nvSpPr>
        <p:spPr>
          <a:xfrm>
            <a:off x="5635535" y="813500"/>
            <a:ext cx="12458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/>
                <a:cs typeface="Arial" panose="020B0604020202020204"/>
              </a:rPr>
              <a:t>Target sequence 1</a:t>
            </a:r>
            <a:endParaRPr lang="ko-KR" altLang="en-US" sz="1000" dirty="0">
              <a:latin typeface="Arial" panose="020B0604020202020204"/>
              <a:cs typeface="Arial" panose="020B0604020202020204"/>
            </a:endParaRPr>
          </a:p>
        </p:txBody>
      </p:sp>
      <p:cxnSp>
        <p:nvCxnSpPr>
          <p:cNvPr id="69" name="직선 연결선 60">
            <a:extLst>
              <a:ext uri="{FF2B5EF4-FFF2-40B4-BE49-F238E27FC236}">
                <a16:creationId xmlns:a16="http://schemas.microsoft.com/office/drawing/2014/main" id="{E5312DE4-E717-2FAF-B9DA-B2B1451D4459}"/>
              </a:ext>
            </a:extLst>
          </p:cNvPr>
          <p:cNvCxnSpPr>
            <a:cxnSpLocks/>
          </p:cNvCxnSpPr>
          <p:nvPr/>
        </p:nvCxnSpPr>
        <p:spPr>
          <a:xfrm>
            <a:off x="4232676" y="739738"/>
            <a:ext cx="5400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직사각형 70"/>
          <p:cNvSpPr/>
          <p:nvPr/>
        </p:nvSpPr>
        <p:spPr>
          <a:xfrm>
            <a:off x="447505" y="5640111"/>
            <a:ext cx="1039770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nalysis of  target genes in T</a:t>
            </a:r>
            <a:r>
              <a:rPr lang="en-US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showing various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s. Cas9 target sequence is marked in red letters, PAM sequence is marked in bold letters, dash represents deletion, insertion of nucleotide is marked in blue letters and ‘*’ represents  nucleotides identical to those in the original wild-type sequence.</a:t>
            </a:r>
          </a:p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l image represents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R analysis of the T</a:t>
            </a:r>
            <a:r>
              <a:rPr lang="en-GB" altLang="ko-KR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tive transgenic plants showing the amplification of a 1839-bp SpCas9 gene and 615-bp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r>
              <a:rPr lang="en-GB" altLang="ko-KR" sz="14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.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neer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kb DNA ladder (Cat.#D-1041) and 100 </a:t>
            </a:r>
            <a:r>
              <a:rPr lang="en-GB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GB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ladder (Cat.#D-1030) were used as size marker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2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53060" y="3364902"/>
            <a:ext cx="1948469" cy="22752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22549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860697" y="5863749"/>
            <a:ext cx="798505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gression plot showing strong positive linear relationship between RNA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and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data with a R-square &gt; 0.75.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data is normalized using 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2</a:t>
            </a:r>
            <a:r>
              <a:rPr lang="en-US" altLang="ko-KR" sz="1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-ΔCT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method and the RNA </a:t>
            </a:r>
            <a:r>
              <a:rPr lang="en-US" altLang="ko-KR" sz="14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seq</a:t>
            </a:r>
            <a:r>
              <a:rPr lang="en-US" altLang="ko-KR" sz="1400" dirty="0">
                <a:solidFill>
                  <a:srgbClr val="000000"/>
                </a:solidFill>
                <a:latin typeface="Times New Roman" panose="02020603050405020304" pitchFamily="18" charset="0"/>
                <a:ea typeface="SimSun"/>
                <a:cs typeface="Times New Roman" panose="02020603050405020304" pitchFamily="18" charset="0"/>
              </a:rPr>
              <a:t> transcript read counts are normalized using TPM (transcript per million).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42" t="7708" r="10896"/>
          <a:stretch/>
        </p:blipFill>
        <p:spPr bwMode="auto">
          <a:xfrm>
            <a:off x="1988287" y="8517"/>
            <a:ext cx="7644811" cy="5855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183193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user\Downloads\Correlation-Mol Func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094" y="1066250"/>
            <a:ext cx="7585658" cy="37928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1621841" y="5026987"/>
            <a:ext cx="8175961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functional enrichment analysis of 801 transcripts that showed to have at least 0.7 absolute value of correlation coefficient in correlation tests between quantitative changes of transcripts and grain weights in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mi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-1-2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b-5-3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c-2-3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. GO functional enrichment analysis was done using online tool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nyGO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77 (http://bioinformatics.sdstate.edu/go/)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24371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/>
          <p:cNvGrpSpPr/>
          <p:nvPr/>
        </p:nvGrpSpPr>
        <p:grpSpPr>
          <a:xfrm>
            <a:off x="632364" y="795225"/>
            <a:ext cx="10985157" cy="4757351"/>
            <a:chOff x="976184" y="1136822"/>
            <a:chExt cx="10985157" cy="4757351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3"/>
            <a:srcRect b="42398"/>
            <a:stretch/>
          </p:blipFill>
          <p:spPr>
            <a:xfrm>
              <a:off x="1559317" y="1306364"/>
              <a:ext cx="9733050" cy="3801321"/>
            </a:xfrm>
            <a:prstGeom prst="rect">
              <a:avLst/>
            </a:prstGeom>
            <a:noFill/>
            <a:ln w="12700">
              <a:noFill/>
            </a:ln>
          </p:spPr>
        </p:pic>
        <p:sp>
          <p:nvSpPr>
            <p:cNvPr id="4" name="직사각형 3"/>
            <p:cNvSpPr/>
            <p:nvPr/>
          </p:nvSpPr>
          <p:spPr>
            <a:xfrm>
              <a:off x="1559317" y="2240540"/>
              <a:ext cx="783507" cy="78377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1374690" y="2822930"/>
              <a:ext cx="10679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6g0567000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직사각형 5"/>
            <p:cNvSpPr/>
            <p:nvPr/>
          </p:nvSpPr>
          <p:spPr>
            <a:xfrm>
              <a:off x="3451577" y="3624972"/>
              <a:ext cx="10679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12g0514500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1559317" y="4729458"/>
              <a:ext cx="933323" cy="47330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" name="직사각형 7"/>
            <p:cNvSpPr/>
            <p:nvPr/>
          </p:nvSpPr>
          <p:spPr>
            <a:xfrm>
              <a:off x="4876788" y="2649517"/>
              <a:ext cx="10679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7g0246200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6789848" y="4165445"/>
              <a:ext cx="10679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2g0100100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7839200" y="3069151"/>
              <a:ext cx="106792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1g0840100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9493518" y="3173901"/>
              <a:ext cx="205697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4g0107900, Os09g0482600 </a:t>
              </a:r>
              <a:endParaRPr lang="ko-KR" alt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직사각형 13"/>
            <p:cNvSpPr/>
            <p:nvPr/>
          </p:nvSpPr>
          <p:spPr>
            <a:xfrm>
              <a:off x="9493518" y="3459131"/>
              <a:ext cx="202170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1g0136200, </a:t>
              </a:r>
              <a:r>
                <a:rPr lang="ko-KR" altLang="en-US" sz="10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s02g0758000</a:t>
              </a:r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6660761" y="4951933"/>
              <a:ext cx="663048" cy="2508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직사각형 15"/>
            <p:cNvSpPr/>
            <p:nvPr/>
          </p:nvSpPr>
          <p:spPr>
            <a:xfrm>
              <a:off x="976184" y="1136822"/>
              <a:ext cx="10985157" cy="475735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8" name="직사각형 2"/>
          <p:cNvSpPr/>
          <p:nvPr/>
        </p:nvSpPr>
        <p:spPr>
          <a:xfrm>
            <a:off x="792084" y="5598711"/>
            <a:ext cx="1057987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.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ndidate genes involved in protein processing in ER.</a:t>
            </a:r>
          </a:p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 of transcripts correlated with grain quality, transcripts sorted to protein processing in ER according to KEGG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thology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KO) were marked to KEGG pathway for protein processing in endoplasmic reticulum pathway (osa04141).</a:t>
            </a:r>
          </a:p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84725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0012" y="405421"/>
            <a:ext cx="3420000" cy="686133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/>
          <a:srcRect b="32831"/>
          <a:stretch/>
        </p:blipFill>
        <p:spPr>
          <a:xfrm>
            <a:off x="491012" y="464180"/>
            <a:ext cx="3420000" cy="671998"/>
          </a:xfrm>
          <a:prstGeom prst="rect">
            <a:avLst/>
          </a:prstGeom>
        </p:spPr>
      </p:pic>
      <p:pic>
        <p:nvPicPr>
          <p:cNvPr id="68" name="그림 6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5512" y="464180"/>
            <a:ext cx="3420000" cy="644813"/>
          </a:xfrm>
          <a:prstGeom prst="rect">
            <a:avLst/>
          </a:prstGeom>
        </p:spPr>
      </p:pic>
      <p:cxnSp>
        <p:nvCxnSpPr>
          <p:cNvPr id="70" name="직선 화살표 연결선 69"/>
          <p:cNvCxnSpPr/>
          <p:nvPr/>
        </p:nvCxnSpPr>
        <p:spPr>
          <a:xfrm>
            <a:off x="3052744" y="1322141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3196797" y="1430403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13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직선 화살표 연결선 71"/>
          <p:cNvCxnSpPr/>
          <p:nvPr/>
        </p:nvCxnSpPr>
        <p:spPr>
          <a:xfrm>
            <a:off x="6867608" y="1283003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6903062" y="1430403"/>
            <a:ext cx="5068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 1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직선 화살표 연결선 73"/>
          <p:cNvCxnSpPr/>
          <p:nvPr/>
        </p:nvCxnSpPr>
        <p:spPr>
          <a:xfrm>
            <a:off x="10115095" y="1263973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10172396" y="1430403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-10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1" name="그림 20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8182" y="1652344"/>
            <a:ext cx="3135191" cy="510120"/>
          </a:xfrm>
          <a:prstGeom prst="rect">
            <a:avLst/>
          </a:prstGeom>
        </p:spPr>
      </p:pic>
      <p:pic>
        <p:nvPicPr>
          <p:cNvPr id="250" name="그림 24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35762" y="1646407"/>
            <a:ext cx="3060000" cy="516057"/>
          </a:xfrm>
          <a:prstGeom prst="rect">
            <a:avLst/>
          </a:prstGeom>
        </p:spPr>
      </p:pic>
      <p:pic>
        <p:nvPicPr>
          <p:cNvPr id="276" name="그림 27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85095" y="1651945"/>
            <a:ext cx="3060000" cy="519692"/>
          </a:xfrm>
          <a:prstGeom prst="rect">
            <a:avLst/>
          </a:prstGeom>
        </p:spPr>
      </p:pic>
      <p:cxnSp>
        <p:nvCxnSpPr>
          <p:cNvPr id="277" name="직선 화살표 연결선 276"/>
          <p:cNvCxnSpPr/>
          <p:nvPr/>
        </p:nvCxnSpPr>
        <p:spPr>
          <a:xfrm>
            <a:off x="3052744" y="2700533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직선 화살표 연결선 277"/>
          <p:cNvCxnSpPr/>
          <p:nvPr/>
        </p:nvCxnSpPr>
        <p:spPr>
          <a:xfrm>
            <a:off x="6867608" y="2661395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직선 화살표 연결선 278"/>
          <p:cNvCxnSpPr/>
          <p:nvPr/>
        </p:nvCxnSpPr>
        <p:spPr>
          <a:xfrm>
            <a:off x="10115095" y="2642365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자유형 284"/>
          <p:cNvSpPr/>
          <p:nvPr/>
        </p:nvSpPr>
        <p:spPr>
          <a:xfrm>
            <a:off x="2119763" y="3088505"/>
            <a:ext cx="1514475" cy="295570"/>
          </a:xfrm>
          <a:custGeom>
            <a:avLst/>
            <a:gdLst>
              <a:gd name="connsiteX0" fmla="*/ 0 w 1514475"/>
              <a:gd name="connsiteY0" fmla="*/ 295570 h 295570"/>
              <a:gd name="connsiteX1" fmla="*/ 428625 w 1514475"/>
              <a:gd name="connsiteY1" fmla="*/ 295 h 295570"/>
              <a:gd name="connsiteX2" fmla="*/ 1009650 w 1514475"/>
              <a:gd name="connsiteY2" fmla="*/ 238420 h 295570"/>
              <a:gd name="connsiteX3" fmla="*/ 1514475 w 1514475"/>
              <a:gd name="connsiteY3" fmla="*/ 143170 h 2955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475" h="295570">
                <a:moveTo>
                  <a:pt x="0" y="295570"/>
                </a:moveTo>
                <a:cubicBezTo>
                  <a:pt x="130175" y="152695"/>
                  <a:pt x="260350" y="9820"/>
                  <a:pt x="428625" y="295"/>
                </a:cubicBezTo>
                <a:cubicBezTo>
                  <a:pt x="596900" y="-9230"/>
                  <a:pt x="828675" y="214607"/>
                  <a:pt x="1009650" y="238420"/>
                </a:cubicBezTo>
                <a:cubicBezTo>
                  <a:pt x="1190625" y="262232"/>
                  <a:pt x="1514475" y="143170"/>
                  <a:pt x="1514475" y="1431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1280886" y="3236290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2948818" y="3174495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자유형 288"/>
          <p:cNvSpPr/>
          <p:nvPr/>
        </p:nvSpPr>
        <p:spPr>
          <a:xfrm>
            <a:off x="5929763" y="3026710"/>
            <a:ext cx="1514475" cy="295570"/>
          </a:xfrm>
          <a:custGeom>
            <a:avLst/>
            <a:gdLst>
              <a:gd name="connsiteX0" fmla="*/ 0 w 1514475"/>
              <a:gd name="connsiteY0" fmla="*/ 295570 h 295570"/>
              <a:gd name="connsiteX1" fmla="*/ 428625 w 1514475"/>
              <a:gd name="connsiteY1" fmla="*/ 295 h 295570"/>
              <a:gd name="connsiteX2" fmla="*/ 1009650 w 1514475"/>
              <a:gd name="connsiteY2" fmla="*/ 238420 h 295570"/>
              <a:gd name="connsiteX3" fmla="*/ 1514475 w 1514475"/>
              <a:gd name="connsiteY3" fmla="*/ 143170 h 2955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475" h="295570">
                <a:moveTo>
                  <a:pt x="0" y="295570"/>
                </a:moveTo>
                <a:cubicBezTo>
                  <a:pt x="130175" y="152695"/>
                  <a:pt x="260350" y="9820"/>
                  <a:pt x="428625" y="295"/>
                </a:cubicBezTo>
                <a:cubicBezTo>
                  <a:pt x="596900" y="-9230"/>
                  <a:pt x="828675" y="214607"/>
                  <a:pt x="1009650" y="238420"/>
                </a:cubicBezTo>
                <a:cubicBezTo>
                  <a:pt x="1190625" y="262232"/>
                  <a:pt x="1514475" y="143170"/>
                  <a:pt x="1514475" y="1431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6758818" y="3112700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자유형 290"/>
          <p:cNvSpPr/>
          <p:nvPr/>
        </p:nvSpPr>
        <p:spPr>
          <a:xfrm>
            <a:off x="9357857" y="3048546"/>
            <a:ext cx="1514475" cy="295570"/>
          </a:xfrm>
          <a:custGeom>
            <a:avLst/>
            <a:gdLst>
              <a:gd name="connsiteX0" fmla="*/ 0 w 1514475"/>
              <a:gd name="connsiteY0" fmla="*/ 295570 h 295570"/>
              <a:gd name="connsiteX1" fmla="*/ 428625 w 1514475"/>
              <a:gd name="connsiteY1" fmla="*/ 295 h 295570"/>
              <a:gd name="connsiteX2" fmla="*/ 1009650 w 1514475"/>
              <a:gd name="connsiteY2" fmla="*/ 238420 h 295570"/>
              <a:gd name="connsiteX3" fmla="*/ 1514475 w 1514475"/>
              <a:gd name="connsiteY3" fmla="*/ 143170 h 2955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475" h="295570">
                <a:moveTo>
                  <a:pt x="0" y="295570"/>
                </a:moveTo>
                <a:cubicBezTo>
                  <a:pt x="130175" y="152695"/>
                  <a:pt x="260350" y="9820"/>
                  <a:pt x="428625" y="295"/>
                </a:cubicBezTo>
                <a:cubicBezTo>
                  <a:pt x="596900" y="-9230"/>
                  <a:pt x="828675" y="214607"/>
                  <a:pt x="1009650" y="238420"/>
                </a:cubicBezTo>
                <a:cubicBezTo>
                  <a:pt x="1190625" y="262232"/>
                  <a:pt x="1514475" y="143170"/>
                  <a:pt x="1514475" y="14317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9959062" y="3019498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>
            <a:off x="2287248" y="3381743"/>
            <a:ext cx="21323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Starting point of reading frame shi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3217628" y="3019498"/>
            <a:ext cx="2156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TC: Premature termination codo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6" name="직선 화살표 연결선 295"/>
          <p:cNvCxnSpPr/>
          <p:nvPr/>
        </p:nvCxnSpPr>
        <p:spPr>
          <a:xfrm flipV="1">
            <a:off x="3408625" y="3228489"/>
            <a:ext cx="0" cy="108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TextBox 296"/>
          <p:cNvSpPr txBox="1"/>
          <p:nvPr/>
        </p:nvSpPr>
        <p:spPr>
          <a:xfrm>
            <a:off x="6959665" y="3007849"/>
            <a:ext cx="401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T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8" name="직선 화살표 연결선 297"/>
          <p:cNvCxnSpPr/>
          <p:nvPr/>
        </p:nvCxnSpPr>
        <p:spPr>
          <a:xfrm flipV="1">
            <a:off x="7160643" y="3196331"/>
            <a:ext cx="0" cy="108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/>
          <p:cNvSpPr txBox="1"/>
          <p:nvPr/>
        </p:nvSpPr>
        <p:spPr>
          <a:xfrm>
            <a:off x="10337718" y="3049254"/>
            <a:ext cx="401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TC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0" name="직선 화살표 연결선 299"/>
          <p:cNvCxnSpPr/>
          <p:nvPr/>
        </p:nvCxnSpPr>
        <p:spPr>
          <a:xfrm flipV="1">
            <a:off x="10538696" y="3218686"/>
            <a:ext cx="0" cy="1080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직선 화살표 연결선 302"/>
          <p:cNvCxnSpPr/>
          <p:nvPr/>
        </p:nvCxnSpPr>
        <p:spPr>
          <a:xfrm>
            <a:off x="3052744" y="3749260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4" name="직선 화살표 연결선 303"/>
          <p:cNvCxnSpPr/>
          <p:nvPr/>
        </p:nvCxnSpPr>
        <p:spPr>
          <a:xfrm>
            <a:off x="6867608" y="3710122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5" name="직선 화살표 연결선 304"/>
          <p:cNvCxnSpPr/>
          <p:nvPr/>
        </p:nvCxnSpPr>
        <p:spPr>
          <a:xfrm>
            <a:off x="10115095" y="3691092"/>
            <a:ext cx="3558" cy="2063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6" name="TextBox 305"/>
          <p:cNvSpPr txBox="1"/>
          <p:nvPr/>
        </p:nvSpPr>
        <p:spPr>
          <a:xfrm>
            <a:off x="97466" y="1485309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Gene edit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306"/>
          <p:cNvSpPr txBox="1"/>
          <p:nvPr/>
        </p:nvSpPr>
        <p:spPr>
          <a:xfrm>
            <a:off x="97466" y="2616748"/>
            <a:ext cx="12119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TextBox 307"/>
          <p:cNvSpPr txBox="1"/>
          <p:nvPr/>
        </p:nvSpPr>
        <p:spPr>
          <a:xfrm>
            <a:off x="97466" y="3963188"/>
            <a:ext cx="1062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Transla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직사각형 2"/>
          <p:cNvSpPr/>
          <p:nvPr/>
        </p:nvSpPr>
        <p:spPr>
          <a:xfrm>
            <a:off x="103365" y="5781119"/>
            <a:ext cx="1198111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ko-KR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8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chematic representation showing process of gene editing by CRISPR-Cas9 and subsequent translation of truncated mutant protein.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elin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ic subunit are shown in grey, basic subunits are in white and mutated protein peptides are shown in red and the black triangle represents aspartic cleavage site in each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utelin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</a:t>
            </a:r>
          </a:p>
          <a:p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49" y="4802372"/>
            <a:ext cx="4116095" cy="249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64060" y="4294738"/>
            <a:ext cx="3749667" cy="4113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4633" y="4781933"/>
            <a:ext cx="4118160" cy="2490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3367" y="4243079"/>
            <a:ext cx="3563958" cy="3955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7842" y="4751782"/>
            <a:ext cx="4099002" cy="2472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14909" y="4180874"/>
            <a:ext cx="3101415" cy="4182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00236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8</TotalTime>
  <Words>1236</Words>
  <Application>Microsoft Office PowerPoint</Application>
  <PresentationFormat>Widescreen</PresentationFormat>
  <Paragraphs>437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맑은 고딕</vt:lpstr>
      <vt:lpstr>SimSun-ExtB</vt:lpstr>
      <vt:lpstr>Arial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youngwon Cho</dc:creator>
  <cp:lastModifiedBy>MDPI</cp:lastModifiedBy>
  <cp:revision>64</cp:revision>
  <cp:lastPrinted>2023-10-20T06:11:13Z</cp:lastPrinted>
  <dcterms:created xsi:type="dcterms:W3CDTF">2023-09-11T04:07:53Z</dcterms:created>
  <dcterms:modified xsi:type="dcterms:W3CDTF">2023-11-29T12:26:04Z</dcterms:modified>
</cp:coreProperties>
</file>